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585" r:id="rId2"/>
  </p:sldIdLst>
  <p:sldSz cx="9144000" cy="6858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0000FF"/>
    <a:srgbClr val="7ABC32"/>
    <a:srgbClr val="464646"/>
    <a:srgbClr val="00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97" autoAdjust="0"/>
    <p:restoredTop sz="93369" autoAdjust="0"/>
  </p:normalViewPr>
  <p:slideViewPr>
    <p:cSldViewPr>
      <p:cViewPr varScale="1">
        <p:scale>
          <a:sx n="82" d="100"/>
          <a:sy n="82" d="100"/>
        </p:scale>
        <p:origin x="1291" y="67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>
            <a:extLst>
              <a:ext uri="{FF2B5EF4-FFF2-40B4-BE49-F238E27FC236}">
                <a16:creationId xmlns:a16="http://schemas.microsoft.com/office/drawing/2014/main" id="{463B3A50-EC67-437A-8F25-AA2DEEF9C75D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2" y="2"/>
            <a:ext cx="2946275" cy="498366"/>
          </a:xfrm>
          <a:prstGeom prst="rect">
            <a:avLst/>
          </a:prstGeom>
        </p:spPr>
        <p:txBody>
          <a:bodyPr vert="horz" lIns="91426" tIns="45713" rIns="91426" bIns="45713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364A93E3-E057-4393-9459-3733C2E2FEBD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49862" y="2"/>
            <a:ext cx="2946275" cy="498366"/>
          </a:xfrm>
          <a:prstGeom prst="rect">
            <a:avLst/>
          </a:prstGeom>
        </p:spPr>
        <p:txBody>
          <a:bodyPr vert="horz" lIns="91426" tIns="45713" rIns="91426" bIns="45713" rtlCol="0"/>
          <a:lstStyle>
            <a:lvl1pPr algn="r">
              <a:defRPr sz="1200"/>
            </a:lvl1pPr>
          </a:lstStyle>
          <a:p>
            <a:fld id="{74597CD1-D7EA-4E4C-8545-23D334D93A35}" type="datetimeFigureOut">
              <a:rPr kumimoji="1" lang="ja-JP" altLang="en-US" smtClean="0"/>
              <a:t>2021/8/1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FDEFBBB-A0FD-47F0-A06C-361FD4C4E811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2" y="9428275"/>
            <a:ext cx="2946275" cy="498366"/>
          </a:xfrm>
          <a:prstGeom prst="rect">
            <a:avLst/>
          </a:prstGeom>
        </p:spPr>
        <p:txBody>
          <a:bodyPr vert="horz" lIns="91426" tIns="45713" rIns="91426" bIns="45713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F86AA335-5BC6-4274-8ED3-F3E1C9AF4BC6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49862" y="9428275"/>
            <a:ext cx="2946275" cy="498366"/>
          </a:xfrm>
          <a:prstGeom prst="rect">
            <a:avLst/>
          </a:prstGeom>
        </p:spPr>
        <p:txBody>
          <a:bodyPr vert="horz" lIns="91426" tIns="45713" rIns="91426" bIns="45713" rtlCol="0" anchor="b"/>
          <a:lstStyle>
            <a:lvl1pPr algn="r">
              <a:defRPr sz="1200"/>
            </a:lvl1pPr>
          </a:lstStyle>
          <a:p>
            <a:fld id="{D5E56BB5-D718-4ED0-8D34-4ACEBFED34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395812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5659" cy="496332"/>
          </a:xfrm>
          <a:prstGeom prst="rect">
            <a:avLst/>
          </a:prstGeom>
        </p:spPr>
        <p:txBody>
          <a:bodyPr vert="horz" lIns="93162" tIns="46582" rIns="93162" bIns="46582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4" y="0"/>
            <a:ext cx="2945659" cy="496332"/>
          </a:xfrm>
          <a:prstGeom prst="rect">
            <a:avLst/>
          </a:prstGeom>
        </p:spPr>
        <p:txBody>
          <a:bodyPr vert="horz" lIns="93162" tIns="46582" rIns="93162" bIns="46582" rtlCol="0"/>
          <a:lstStyle>
            <a:lvl1pPr algn="r">
              <a:defRPr sz="1200"/>
            </a:lvl1pPr>
          </a:lstStyle>
          <a:p>
            <a:fld id="{75299133-6C75-4558-9524-1683EB80439F}" type="datetimeFigureOut">
              <a:rPr lang="en-US" smtClean="0"/>
              <a:pPr/>
              <a:t>8/17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62" tIns="46582" rIns="93162" bIns="46582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155"/>
            <a:ext cx="5438140" cy="4466987"/>
          </a:xfrm>
          <a:prstGeom prst="rect">
            <a:avLst/>
          </a:prstGeom>
        </p:spPr>
        <p:txBody>
          <a:bodyPr vert="horz" lIns="93162" tIns="46582" rIns="93162" bIns="46582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9428584"/>
            <a:ext cx="2945659" cy="496332"/>
          </a:xfrm>
          <a:prstGeom prst="rect">
            <a:avLst/>
          </a:prstGeom>
        </p:spPr>
        <p:txBody>
          <a:bodyPr vert="horz" lIns="93162" tIns="46582" rIns="93162" bIns="46582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4" y="9428584"/>
            <a:ext cx="2945659" cy="496332"/>
          </a:xfrm>
          <a:prstGeom prst="rect">
            <a:avLst/>
          </a:prstGeom>
        </p:spPr>
        <p:txBody>
          <a:bodyPr vert="horz" lIns="93162" tIns="46582" rIns="93162" bIns="46582" rtlCol="0" anchor="b"/>
          <a:lstStyle>
            <a:lvl1pPr algn="r">
              <a:defRPr sz="1200"/>
            </a:lvl1pPr>
          </a:lstStyle>
          <a:p>
            <a:fld id="{621572A8-9031-41C0-808B-67CB58E6C5E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35249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fld id="{DEEA154D-C1EC-43DE-8FE1-98BBEAF142D8}" type="slidenum">
              <a:rPr lang="en-US" altLang="ja-JP" smtClean="0"/>
              <a:pPr/>
              <a:t>1</a:t>
            </a:fld>
            <a:endParaRPr lang="en-US" altLang="ja-JP"/>
          </a:p>
        </p:txBody>
      </p:sp>
      <p:sp>
        <p:nvSpPr>
          <p:cNvPr id="14339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xfrm>
            <a:off x="915988" y="744538"/>
            <a:ext cx="4965700" cy="3724275"/>
          </a:xfrm>
          <a:ln/>
        </p:spPr>
      </p:sp>
      <p:sp>
        <p:nvSpPr>
          <p:cNvPr id="14340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endParaRPr lang="ja-JP" altLang="ja-JP" dirty="0"/>
          </a:p>
        </p:txBody>
      </p:sp>
    </p:spTree>
    <p:extLst>
      <p:ext uri="{BB962C8B-B14F-4D97-AF65-F5344CB8AC3E}">
        <p14:creationId xmlns:p14="http://schemas.microsoft.com/office/powerpoint/2010/main" val="275272087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33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8/1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8/1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46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46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8/1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8/1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8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8/1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6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6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8/1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9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9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8/17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8/17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8/17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4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8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4" y="1435103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8/1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8/1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6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8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621B25-79C8-4BE8-B89E-C8E6BF116A78}" type="datetimeFigureOut">
              <a:rPr lang="en-US" smtClean="0"/>
              <a:pPr/>
              <a:t>8/1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8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8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02D6038E-5028-4957-A6D1-E00876FF0080}"/>
              </a:ext>
            </a:extLst>
          </p:cNvPr>
          <p:cNvSpPr txBox="1"/>
          <p:nvPr/>
        </p:nvSpPr>
        <p:spPr>
          <a:xfrm>
            <a:off x="86922" y="175292"/>
            <a:ext cx="36773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4" name="表 24">
            <a:extLst>
              <a:ext uri="{FF2B5EF4-FFF2-40B4-BE49-F238E27FC236}">
                <a16:creationId xmlns:a16="http://schemas.microsoft.com/office/drawing/2014/main" id="{631CE31F-AEFE-45A8-A9E0-AADB5569537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56846398"/>
              </p:ext>
            </p:extLst>
          </p:nvPr>
        </p:nvGraphicFramePr>
        <p:xfrm>
          <a:off x="554703" y="3856784"/>
          <a:ext cx="3811200" cy="11074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19200">
                  <a:extLst>
                    <a:ext uri="{9D8B030D-6E8A-4147-A177-3AD203B41FA5}">
                      <a16:colId xmlns:a16="http://schemas.microsoft.com/office/drawing/2014/main" val="1234284937"/>
                    </a:ext>
                  </a:extLst>
                </a:gridCol>
                <a:gridCol w="432000">
                  <a:extLst>
                    <a:ext uri="{9D8B030D-6E8A-4147-A177-3AD203B41FA5}">
                      <a16:colId xmlns:a16="http://schemas.microsoft.com/office/drawing/2014/main" val="2411588898"/>
                    </a:ext>
                  </a:extLst>
                </a:gridCol>
                <a:gridCol w="432000">
                  <a:extLst>
                    <a:ext uri="{9D8B030D-6E8A-4147-A177-3AD203B41FA5}">
                      <a16:colId xmlns:a16="http://schemas.microsoft.com/office/drawing/2014/main" val="3342229584"/>
                    </a:ext>
                  </a:extLst>
                </a:gridCol>
                <a:gridCol w="432000">
                  <a:extLst>
                    <a:ext uri="{9D8B030D-6E8A-4147-A177-3AD203B41FA5}">
                      <a16:colId xmlns:a16="http://schemas.microsoft.com/office/drawing/2014/main" val="4090752787"/>
                    </a:ext>
                  </a:extLst>
                </a:gridCol>
                <a:gridCol w="432000">
                  <a:extLst>
                    <a:ext uri="{9D8B030D-6E8A-4147-A177-3AD203B41FA5}">
                      <a16:colId xmlns:a16="http://schemas.microsoft.com/office/drawing/2014/main" val="3103706498"/>
                    </a:ext>
                  </a:extLst>
                </a:gridCol>
                <a:gridCol w="432000">
                  <a:extLst>
                    <a:ext uri="{9D8B030D-6E8A-4147-A177-3AD203B41FA5}">
                      <a16:colId xmlns:a16="http://schemas.microsoft.com/office/drawing/2014/main" val="3821091457"/>
                    </a:ext>
                  </a:extLst>
                </a:gridCol>
                <a:gridCol w="432000">
                  <a:extLst>
                    <a:ext uri="{9D8B030D-6E8A-4147-A177-3AD203B41FA5}">
                      <a16:colId xmlns:a16="http://schemas.microsoft.com/office/drawing/2014/main" val="4209548077"/>
                    </a:ext>
                  </a:extLst>
                </a:gridCol>
              </a:tblGrid>
              <a:tr h="139700"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S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6"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ar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88201164"/>
                  </a:ext>
                </a:extLst>
              </a:tr>
              <a:tr h="13970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53382290"/>
                  </a:ext>
                </a:extLst>
              </a:tr>
              <a:tr h="27940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r>
                        <a:rPr kumimoji="1" lang="en-US" altLang="ja-JP" sz="12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</a:t>
                      </a:r>
                      <a:r>
                        <a:rPr kumimoji="1" lang="en-US" altLang="ja-JP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2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cleatum</a:t>
                      </a:r>
                      <a:r>
                        <a:rPr kumimoji="1" lang="en-US" altLang="ja-JP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-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3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5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9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7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10002038"/>
                  </a:ext>
                </a:extLst>
              </a:tr>
              <a:tr h="27940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r>
                        <a:rPr kumimoji="1" lang="en-US" altLang="ja-JP" sz="12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</a:t>
                      </a:r>
                      <a:r>
                        <a:rPr kumimoji="1" lang="en-US" altLang="ja-JP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2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cleatum</a:t>
                      </a:r>
                      <a:r>
                        <a:rPr kumimoji="1" lang="en-US" altLang="ja-JP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+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37610399"/>
                  </a:ext>
                </a:extLst>
              </a:tr>
            </a:tbl>
          </a:graphicData>
        </a:graphic>
      </p:graphicFrame>
      <p:graphicFrame>
        <p:nvGraphicFramePr>
          <p:cNvPr id="27" name="表 24">
            <a:extLst>
              <a:ext uri="{FF2B5EF4-FFF2-40B4-BE49-F238E27FC236}">
                <a16:creationId xmlns:a16="http://schemas.microsoft.com/office/drawing/2014/main" id="{4A2512BA-BE2C-44C5-B363-D3AA3D444BD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73153323"/>
              </p:ext>
            </p:extLst>
          </p:nvPr>
        </p:nvGraphicFramePr>
        <p:xfrm>
          <a:off x="4799400" y="3835119"/>
          <a:ext cx="3811200" cy="11074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19200">
                  <a:extLst>
                    <a:ext uri="{9D8B030D-6E8A-4147-A177-3AD203B41FA5}">
                      <a16:colId xmlns:a16="http://schemas.microsoft.com/office/drawing/2014/main" val="1234284937"/>
                    </a:ext>
                  </a:extLst>
                </a:gridCol>
                <a:gridCol w="432000">
                  <a:extLst>
                    <a:ext uri="{9D8B030D-6E8A-4147-A177-3AD203B41FA5}">
                      <a16:colId xmlns:a16="http://schemas.microsoft.com/office/drawing/2014/main" val="2411588898"/>
                    </a:ext>
                  </a:extLst>
                </a:gridCol>
                <a:gridCol w="432000">
                  <a:extLst>
                    <a:ext uri="{9D8B030D-6E8A-4147-A177-3AD203B41FA5}">
                      <a16:colId xmlns:a16="http://schemas.microsoft.com/office/drawing/2014/main" val="3342229584"/>
                    </a:ext>
                  </a:extLst>
                </a:gridCol>
                <a:gridCol w="432000">
                  <a:extLst>
                    <a:ext uri="{9D8B030D-6E8A-4147-A177-3AD203B41FA5}">
                      <a16:colId xmlns:a16="http://schemas.microsoft.com/office/drawing/2014/main" val="4090752787"/>
                    </a:ext>
                  </a:extLst>
                </a:gridCol>
                <a:gridCol w="432000">
                  <a:extLst>
                    <a:ext uri="{9D8B030D-6E8A-4147-A177-3AD203B41FA5}">
                      <a16:colId xmlns:a16="http://schemas.microsoft.com/office/drawing/2014/main" val="3103706498"/>
                    </a:ext>
                  </a:extLst>
                </a:gridCol>
                <a:gridCol w="432000">
                  <a:extLst>
                    <a:ext uri="{9D8B030D-6E8A-4147-A177-3AD203B41FA5}">
                      <a16:colId xmlns:a16="http://schemas.microsoft.com/office/drawing/2014/main" val="3821091457"/>
                    </a:ext>
                  </a:extLst>
                </a:gridCol>
                <a:gridCol w="432000">
                  <a:extLst>
                    <a:ext uri="{9D8B030D-6E8A-4147-A177-3AD203B41FA5}">
                      <a16:colId xmlns:a16="http://schemas.microsoft.com/office/drawing/2014/main" val="4209548077"/>
                    </a:ext>
                  </a:extLst>
                </a:gridCol>
              </a:tblGrid>
              <a:tr h="139700"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FS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6"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ar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88201164"/>
                  </a:ext>
                </a:extLst>
              </a:tr>
              <a:tr h="13970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28055693"/>
                  </a:ext>
                </a:extLst>
              </a:tr>
              <a:tr h="27940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r>
                        <a:rPr kumimoji="1" lang="en-US" altLang="ja-JP" sz="12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</a:t>
                      </a:r>
                      <a:r>
                        <a:rPr kumimoji="1" lang="en-US" altLang="ja-JP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2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cleatum</a:t>
                      </a:r>
                      <a:r>
                        <a:rPr kumimoji="1" lang="en-US" altLang="ja-JP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-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3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9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10002038"/>
                  </a:ext>
                </a:extLst>
              </a:tr>
              <a:tr h="27940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r>
                        <a:rPr kumimoji="1" lang="en-US" altLang="ja-JP" sz="12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</a:t>
                      </a:r>
                      <a:r>
                        <a:rPr kumimoji="1" lang="en-US" altLang="ja-JP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2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cleatum</a:t>
                      </a:r>
                      <a:r>
                        <a:rPr kumimoji="1" lang="en-US" altLang="ja-JP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+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37610399"/>
                  </a:ext>
                </a:extLst>
              </a:tr>
            </a:tbl>
          </a:graphicData>
        </a:graphic>
      </p:graphicFrame>
      <p:sp>
        <p:nvSpPr>
          <p:cNvPr id="126" name="テキスト ボックス 125">
            <a:extLst>
              <a:ext uri="{FF2B5EF4-FFF2-40B4-BE49-F238E27FC236}">
                <a16:creationId xmlns:a16="http://schemas.microsoft.com/office/drawing/2014/main" id="{CB3DBA5E-3AB5-475F-BC1C-88A23725EE8F}"/>
              </a:ext>
            </a:extLst>
          </p:cNvPr>
          <p:cNvSpPr txBox="1"/>
          <p:nvPr/>
        </p:nvSpPr>
        <p:spPr>
          <a:xfrm>
            <a:off x="554703" y="3568704"/>
            <a:ext cx="12770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at risk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7" name="テキスト ボックス 126">
            <a:extLst>
              <a:ext uri="{FF2B5EF4-FFF2-40B4-BE49-F238E27FC236}">
                <a16:creationId xmlns:a16="http://schemas.microsoft.com/office/drawing/2014/main" id="{EC81CD13-4C41-4214-8DD7-9816473A5195}"/>
              </a:ext>
            </a:extLst>
          </p:cNvPr>
          <p:cNvSpPr txBox="1"/>
          <p:nvPr/>
        </p:nvSpPr>
        <p:spPr>
          <a:xfrm>
            <a:off x="4799400" y="3564185"/>
            <a:ext cx="12770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at risk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id="{886DE187-404D-43C1-B7EF-5177F840FBF9}"/>
              </a:ext>
            </a:extLst>
          </p:cNvPr>
          <p:cNvSpPr txBox="1"/>
          <p:nvPr/>
        </p:nvSpPr>
        <p:spPr>
          <a:xfrm>
            <a:off x="5603752" y="3347203"/>
            <a:ext cx="25942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>
                <a:latin typeface="Times New Roman" panose="02020603050405020304" pitchFamily="18" charset="0"/>
                <a:cs typeface="Times New Roman" panose="02020603050405020304" pitchFamily="18" charset="0"/>
              </a:rPr>
              <a:t>Relapse-free 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rvival (years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3" name="Text Box 94">
            <a:extLst>
              <a:ext uri="{FF2B5EF4-FFF2-40B4-BE49-F238E27FC236}">
                <a16:creationId xmlns:a16="http://schemas.microsoft.com/office/drawing/2014/main" id="{7FD3BB99-05F2-47D6-A25A-9446DE07CF49}"/>
              </a:ext>
            </a:extLst>
          </p:cNvPr>
          <p:cNvSpPr txBox="1">
            <a:spLocks noChangeArrowheads="1"/>
          </p:cNvSpPr>
          <p:nvPr/>
        </p:nvSpPr>
        <p:spPr bwMode="auto">
          <a:xfrm rot="10800000">
            <a:off x="4679919" y="1044546"/>
            <a:ext cx="400110" cy="205034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eaVert" wrap="square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>
                <a:tab pos="265113" algn="l"/>
              </a:tabLst>
              <a:defRPr/>
            </a:pPr>
            <a:r>
              <a:rPr kumimoji="0" lang="en-US" altLang="ja-JP" sz="140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charset="-128"/>
                <a:cs typeface="Times New Roman" panose="02020603050405020304" pitchFamily="18" charset="0"/>
              </a:rPr>
              <a:t>Survival probability</a:t>
            </a:r>
            <a:endParaRPr kumimoji="0" lang="ja-JP" altLang="en-US" sz="1400" i="0" u="none" strike="noStrike" kern="0" cap="none" spc="0" normalizeH="0" baseline="0" noProof="0" dirty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  <a:latin typeface="Times New Roman" panose="02020603050405020304" pitchFamily="18" charset="0"/>
              <a:ea typeface="ＭＳ Ｐゴシック" charset="-128"/>
              <a:cs typeface="Times New Roman" panose="02020603050405020304" pitchFamily="18" charset="0"/>
            </a:endParaRPr>
          </a:p>
        </p:txBody>
      </p:sp>
      <p:sp>
        <p:nvSpPr>
          <p:cNvPr id="129" name="テキスト ボックス 128">
            <a:extLst>
              <a:ext uri="{FF2B5EF4-FFF2-40B4-BE49-F238E27FC236}">
                <a16:creationId xmlns:a16="http://schemas.microsoft.com/office/drawing/2014/main" id="{D9B9F8B3-5C45-4104-9143-0ECBE4B2640A}"/>
              </a:ext>
            </a:extLst>
          </p:cNvPr>
          <p:cNvSpPr txBox="1"/>
          <p:nvPr/>
        </p:nvSpPr>
        <p:spPr>
          <a:xfrm>
            <a:off x="6685176" y="1209070"/>
            <a:ext cx="18030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Times New Roman" panose="02020603050405020304" pitchFamily="18" charset="0"/>
                <a:ea typeface="HGP創英角ｺﾞｼｯｸUB" panose="020B0900000000000000" pitchFamily="50" charset="-128"/>
                <a:cs typeface="Times New Roman" panose="02020603050405020304" pitchFamily="18" charset="0"/>
              </a:rPr>
              <a:t>Log-rank </a:t>
            </a:r>
            <a:r>
              <a:rPr kumimoji="1" lang="en-US" altLang="ja-JP" sz="1400" i="1" dirty="0">
                <a:latin typeface="Times New Roman" panose="02020603050405020304" pitchFamily="18" charset="0"/>
                <a:ea typeface="HGP創英角ｺﾞｼｯｸUB" panose="020B0900000000000000" pitchFamily="50" charset="-128"/>
                <a:cs typeface="Times New Roman" panose="02020603050405020304" pitchFamily="18" charset="0"/>
              </a:rPr>
              <a:t>P </a:t>
            </a:r>
            <a:r>
              <a:rPr kumimoji="1" lang="en-US" altLang="ja-JP" sz="1400" dirty="0">
                <a:latin typeface="Times New Roman" panose="02020603050405020304" pitchFamily="18" charset="0"/>
                <a:ea typeface="HGP創英角ｺﾞｼｯｸUB" panose="020B0900000000000000" pitchFamily="50" charset="-128"/>
                <a:cs typeface="Times New Roman" panose="02020603050405020304" pitchFamily="18" charset="0"/>
              </a:rPr>
              <a:t>= 0</a:t>
            </a:r>
            <a:r>
              <a:rPr lang="en-US" altLang="ja-JP" sz="1400" dirty="0">
                <a:latin typeface="Times New Roman" panose="02020603050405020304" pitchFamily="18" charset="0"/>
                <a:ea typeface="HGP創英角ｺﾞｼｯｸUB" panose="020B0900000000000000" pitchFamily="50" charset="-128"/>
                <a:cs typeface="Times New Roman" panose="02020603050405020304" pitchFamily="18" charset="0"/>
              </a:rPr>
              <a:t>.41</a:t>
            </a:r>
            <a:endParaRPr kumimoji="1" lang="en-US" altLang="ja-JP" sz="1400" dirty="0">
              <a:latin typeface="Times New Roman" panose="02020603050405020304" pitchFamily="18" charset="0"/>
              <a:ea typeface="HGP創英角ｺﾞｼｯｸUB" panose="020B09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id="{661C03B9-A6DB-4199-A0AF-3B4AE959FE0B}"/>
              </a:ext>
            </a:extLst>
          </p:cNvPr>
          <p:cNvSpPr txBox="1"/>
          <p:nvPr/>
        </p:nvSpPr>
        <p:spPr>
          <a:xfrm>
            <a:off x="1525683" y="3351349"/>
            <a:ext cx="23461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all survival (years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2" name="Text Box 94">
            <a:extLst>
              <a:ext uri="{FF2B5EF4-FFF2-40B4-BE49-F238E27FC236}">
                <a16:creationId xmlns:a16="http://schemas.microsoft.com/office/drawing/2014/main" id="{6BC52AD5-FCDD-4345-8AF5-3704C6D2D95A}"/>
              </a:ext>
            </a:extLst>
          </p:cNvPr>
          <p:cNvSpPr txBox="1">
            <a:spLocks noChangeArrowheads="1"/>
          </p:cNvSpPr>
          <p:nvPr/>
        </p:nvSpPr>
        <p:spPr bwMode="auto">
          <a:xfrm rot="10800000">
            <a:off x="441091" y="1038882"/>
            <a:ext cx="400110" cy="205034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eaVert" wrap="square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>
                <a:tab pos="265113" algn="l"/>
              </a:tabLst>
              <a:defRPr/>
            </a:pPr>
            <a:r>
              <a:rPr lang="en-US" altLang="ja-JP" sz="1400" kern="0" dirty="0">
                <a:solidFill>
                  <a:sysClr val="windowText" lastClr="000000"/>
                </a:solidFill>
                <a:latin typeface="Times New Roman" panose="02020603050405020304" pitchFamily="18" charset="0"/>
                <a:ea typeface="ＭＳ Ｐゴシック" charset="-128"/>
                <a:cs typeface="Times New Roman" panose="02020603050405020304" pitchFamily="18" charset="0"/>
              </a:rPr>
              <a:t>Survival probability</a:t>
            </a:r>
            <a:endParaRPr kumimoji="0" lang="ja-JP" altLang="en-US" sz="1400" i="0" u="none" strike="noStrike" kern="0" cap="none" spc="0" normalizeH="0" baseline="0" noProof="0" dirty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  <a:latin typeface="Times New Roman" panose="02020603050405020304" pitchFamily="18" charset="0"/>
              <a:ea typeface="ＭＳ Ｐゴシック" charset="-128"/>
              <a:cs typeface="Times New Roman" panose="02020603050405020304" pitchFamily="18" charset="0"/>
            </a:endParaRPr>
          </a:p>
        </p:txBody>
      </p:sp>
      <p:sp>
        <p:nvSpPr>
          <p:cNvPr id="128" name="テキスト ボックス 127">
            <a:extLst>
              <a:ext uri="{FF2B5EF4-FFF2-40B4-BE49-F238E27FC236}">
                <a16:creationId xmlns:a16="http://schemas.microsoft.com/office/drawing/2014/main" id="{5559E82B-5C96-46B3-A54F-0D9886A20DDF}"/>
              </a:ext>
            </a:extLst>
          </p:cNvPr>
          <p:cNvSpPr txBox="1"/>
          <p:nvPr/>
        </p:nvSpPr>
        <p:spPr>
          <a:xfrm>
            <a:off x="1232251" y="2589450"/>
            <a:ext cx="16380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Times New Roman" panose="02020603050405020304" pitchFamily="18" charset="0"/>
                <a:ea typeface="HGP創英角ｺﾞｼｯｸUB" panose="020B0900000000000000" pitchFamily="50" charset="-128"/>
                <a:cs typeface="Times New Roman" panose="02020603050405020304" pitchFamily="18" charset="0"/>
              </a:rPr>
              <a:t>Log-rank </a:t>
            </a:r>
            <a:r>
              <a:rPr kumimoji="1" lang="en-US" altLang="ja-JP" sz="1400" i="1" dirty="0">
                <a:latin typeface="Times New Roman" panose="02020603050405020304" pitchFamily="18" charset="0"/>
                <a:ea typeface="HGP創英角ｺﾞｼｯｸUB" panose="020B0900000000000000" pitchFamily="50" charset="-128"/>
                <a:cs typeface="Times New Roman" panose="02020603050405020304" pitchFamily="18" charset="0"/>
              </a:rPr>
              <a:t>P </a:t>
            </a:r>
            <a:r>
              <a:rPr kumimoji="1" lang="en-US" altLang="ja-JP" sz="1400" dirty="0">
                <a:latin typeface="Times New Roman" panose="02020603050405020304" pitchFamily="18" charset="0"/>
                <a:ea typeface="HGP創英角ｺﾞｼｯｸUB" panose="020B0900000000000000" pitchFamily="50" charset="-128"/>
                <a:cs typeface="Times New Roman" panose="02020603050405020304" pitchFamily="18" charset="0"/>
              </a:rPr>
              <a:t>= 0</a:t>
            </a:r>
            <a:r>
              <a:rPr lang="en-US" altLang="ja-JP" sz="1400" dirty="0">
                <a:latin typeface="Times New Roman" panose="02020603050405020304" pitchFamily="18" charset="0"/>
                <a:ea typeface="HGP創英角ｺﾞｼｯｸUB" panose="020B0900000000000000" pitchFamily="50" charset="-128"/>
                <a:cs typeface="Times New Roman" panose="02020603050405020304" pitchFamily="18" charset="0"/>
              </a:rPr>
              <a:t>.15</a:t>
            </a:r>
            <a:endParaRPr kumimoji="1" lang="en-US" altLang="ja-JP" sz="1400" dirty="0">
              <a:latin typeface="Times New Roman" panose="02020603050405020304" pitchFamily="18" charset="0"/>
              <a:ea typeface="HGP創英角ｺﾞｼｯｸUB" panose="020B09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43" name="テキスト ボックス 142">
            <a:extLst>
              <a:ext uri="{FF2B5EF4-FFF2-40B4-BE49-F238E27FC236}">
                <a16:creationId xmlns:a16="http://schemas.microsoft.com/office/drawing/2014/main" id="{D833DD19-C27C-4826-BCD6-74A71046600A}"/>
              </a:ext>
            </a:extLst>
          </p:cNvPr>
          <p:cNvSpPr txBox="1"/>
          <p:nvPr/>
        </p:nvSpPr>
        <p:spPr>
          <a:xfrm>
            <a:off x="4482695" y="656522"/>
            <a:ext cx="277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4" name="テキスト ボックス 143">
            <a:extLst>
              <a:ext uri="{FF2B5EF4-FFF2-40B4-BE49-F238E27FC236}">
                <a16:creationId xmlns:a16="http://schemas.microsoft.com/office/drawing/2014/main" id="{98D382A9-B33A-4D50-883F-641D94D661D7}"/>
              </a:ext>
            </a:extLst>
          </p:cNvPr>
          <p:cNvSpPr txBox="1"/>
          <p:nvPr/>
        </p:nvSpPr>
        <p:spPr>
          <a:xfrm>
            <a:off x="277703" y="618005"/>
            <a:ext cx="277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94" name="グループ化 193">
            <a:extLst>
              <a:ext uri="{FF2B5EF4-FFF2-40B4-BE49-F238E27FC236}">
                <a16:creationId xmlns:a16="http://schemas.microsoft.com/office/drawing/2014/main" id="{01685C9C-C2DB-48EB-8C76-151C8BD50AB0}"/>
              </a:ext>
            </a:extLst>
          </p:cNvPr>
          <p:cNvGrpSpPr/>
          <p:nvPr/>
        </p:nvGrpSpPr>
        <p:grpSpPr>
          <a:xfrm>
            <a:off x="854075" y="956560"/>
            <a:ext cx="3440981" cy="2423656"/>
            <a:chOff x="930275" y="757238"/>
            <a:chExt cx="3440981" cy="2423656"/>
          </a:xfrm>
        </p:grpSpPr>
        <p:sp>
          <p:nvSpPr>
            <p:cNvPr id="5" name="Line 6">
              <a:extLst>
                <a:ext uri="{FF2B5EF4-FFF2-40B4-BE49-F238E27FC236}">
                  <a16:creationId xmlns:a16="http://schemas.microsoft.com/office/drawing/2014/main" id="{C6CC8123-C016-4DAD-8D8D-33377F82806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155700" y="2886075"/>
              <a:ext cx="66675" cy="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Rectangle 7">
              <a:extLst>
                <a:ext uri="{FF2B5EF4-FFF2-40B4-BE49-F238E27FC236}">
                  <a16:creationId xmlns:a16="http://schemas.microsoft.com/office/drawing/2014/main" id="{3DC1B71A-A6CC-4052-8F36-7FD028B695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30275" y="2784475"/>
              <a:ext cx="22442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0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Line 8">
              <a:extLst>
                <a:ext uri="{FF2B5EF4-FFF2-40B4-BE49-F238E27FC236}">
                  <a16:creationId xmlns:a16="http://schemas.microsoft.com/office/drawing/2014/main" id="{62D8477E-C1E2-4158-BF19-FEB38AD842B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189038" y="2682875"/>
              <a:ext cx="33338" cy="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Line 9">
              <a:extLst>
                <a:ext uri="{FF2B5EF4-FFF2-40B4-BE49-F238E27FC236}">
                  <a16:creationId xmlns:a16="http://schemas.microsoft.com/office/drawing/2014/main" id="{286EC5D3-2F8B-48EB-BEC1-C33D76916D2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155700" y="2479675"/>
              <a:ext cx="66675" cy="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Rectangle 10">
              <a:extLst>
                <a:ext uri="{FF2B5EF4-FFF2-40B4-BE49-F238E27FC236}">
                  <a16:creationId xmlns:a16="http://schemas.microsoft.com/office/drawing/2014/main" id="{0DFA5758-0317-49A8-9B84-2087450209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30275" y="2379663"/>
              <a:ext cx="22442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2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Line 11">
              <a:extLst>
                <a:ext uri="{FF2B5EF4-FFF2-40B4-BE49-F238E27FC236}">
                  <a16:creationId xmlns:a16="http://schemas.microsoft.com/office/drawing/2014/main" id="{B6B04848-5347-43A1-B6AA-8A7C114087F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189038" y="2278063"/>
              <a:ext cx="33338" cy="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Line 12">
              <a:extLst>
                <a:ext uri="{FF2B5EF4-FFF2-40B4-BE49-F238E27FC236}">
                  <a16:creationId xmlns:a16="http://schemas.microsoft.com/office/drawing/2014/main" id="{2EAFD345-217C-4614-AEA1-44B886D2E29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155700" y="2074863"/>
              <a:ext cx="66675" cy="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Rectangle 13">
              <a:extLst>
                <a:ext uri="{FF2B5EF4-FFF2-40B4-BE49-F238E27FC236}">
                  <a16:creationId xmlns:a16="http://schemas.microsoft.com/office/drawing/2014/main" id="{FB1CBB4C-96C9-466A-9910-F2EE204E53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30275" y="1973263"/>
              <a:ext cx="22442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4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Line 14">
              <a:extLst>
                <a:ext uri="{FF2B5EF4-FFF2-40B4-BE49-F238E27FC236}">
                  <a16:creationId xmlns:a16="http://schemas.microsoft.com/office/drawing/2014/main" id="{8B7A2FF8-7A05-4CA9-B920-E938CA8900F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189038" y="1871663"/>
              <a:ext cx="33338" cy="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Line 15">
              <a:extLst>
                <a:ext uri="{FF2B5EF4-FFF2-40B4-BE49-F238E27FC236}">
                  <a16:creationId xmlns:a16="http://schemas.microsoft.com/office/drawing/2014/main" id="{15F66638-1AA5-4167-A32E-A4AE7BE33E6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155700" y="1670050"/>
              <a:ext cx="66675" cy="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Rectangle 16">
              <a:extLst>
                <a:ext uri="{FF2B5EF4-FFF2-40B4-BE49-F238E27FC236}">
                  <a16:creationId xmlns:a16="http://schemas.microsoft.com/office/drawing/2014/main" id="{DC4FD873-4289-4F44-94F9-3FF96A2A0A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30275" y="1568450"/>
              <a:ext cx="22442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6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Line 17">
              <a:extLst>
                <a:ext uri="{FF2B5EF4-FFF2-40B4-BE49-F238E27FC236}">
                  <a16:creationId xmlns:a16="http://schemas.microsoft.com/office/drawing/2014/main" id="{B7F9FFD6-86D0-45C1-968A-6DAF074C6A9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189038" y="1466850"/>
              <a:ext cx="33338" cy="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Line 18">
              <a:extLst>
                <a:ext uri="{FF2B5EF4-FFF2-40B4-BE49-F238E27FC236}">
                  <a16:creationId xmlns:a16="http://schemas.microsoft.com/office/drawing/2014/main" id="{C8414E8B-DE6D-4256-834A-8F9FC14D814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155700" y="1263650"/>
              <a:ext cx="66675" cy="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Rectangle 19">
              <a:extLst>
                <a:ext uri="{FF2B5EF4-FFF2-40B4-BE49-F238E27FC236}">
                  <a16:creationId xmlns:a16="http://schemas.microsoft.com/office/drawing/2014/main" id="{300EE241-2629-418E-B271-E43879962C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30275" y="1163638"/>
              <a:ext cx="22442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8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Line 20">
              <a:extLst>
                <a:ext uri="{FF2B5EF4-FFF2-40B4-BE49-F238E27FC236}">
                  <a16:creationId xmlns:a16="http://schemas.microsoft.com/office/drawing/2014/main" id="{E550792D-A4C2-480A-B8D0-77D85D38393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189038" y="1060450"/>
              <a:ext cx="33338" cy="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Line 21">
              <a:extLst>
                <a:ext uri="{FF2B5EF4-FFF2-40B4-BE49-F238E27FC236}">
                  <a16:creationId xmlns:a16="http://schemas.microsoft.com/office/drawing/2014/main" id="{F7B363B5-F125-47AD-BF4B-72376DC247A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155700" y="858838"/>
              <a:ext cx="66675" cy="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Rectangle 22">
              <a:extLst>
                <a:ext uri="{FF2B5EF4-FFF2-40B4-BE49-F238E27FC236}">
                  <a16:creationId xmlns:a16="http://schemas.microsoft.com/office/drawing/2014/main" id="{A48CC104-DD49-43FA-81F2-6A773D7012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30275" y="757238"/>
              <a:ext cx="22442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.0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Freeform 27">
              <a:extLst>
                <a:ext uri="{FF2B5EF4-FFF2-40B4-BE49-F238E27FC236}">
                  <a16:creationId xmlns:a16="http://schemas.microsoft.com/office/drawing/2014/main" id="{259B64DE-46B1-4D4A-A24E-F99A10E6892D}"/>
                </a:ext>
              </a:extLst>
            </p:cNvPr>
            <p:cNvSpPr>
              <a:spLocks/>
            </p:cNvSpPr>
            <p:nvPr/>
          </p:nvSpPr>
          <p:spPr bwMode="auto">
            <a:xfrm>
              <a:off x="1222375" y="858838"/>
              <a:ext cx="3105150" cy="855662"/>
            </a:xfrm>
            <a:custGeom>
              <a:avLst/>
              <a:gdLst>
                <a:gd name="T0" fmla="*/ 14 w 1956"/>
                <a:gd name="T1" fmla="*/ 7 h 539"/>
                <a:gd name="T2" fmla="*/ 71 w 1956"/>
                <a:gd name="T3" fmla="*/ 7 h 539"/>
                <a:gd name="T4" fmla="*/ 135 w 1956"/>
                <a:gd name="T5" fmla="*/ 14 h 539"/>
                <a:gd name="T6" fmla="*/ 156 w 1956"/>
                <a:gd name="T7" fmla="*/ 28 h 539"/>
                <a:gd name="T8" fmla="*/ 199 w 1956"/>
                <a:gd name="T9" fmla="*/ 35 h 539"/>
                <a:gd name="T10" fmla="*/ 291 w 1956"/>
                <a:gd name="T11" fmla="*/ 35 h 539"/>
                <a:gd name="T12" fmla="*/ 333 w 1956"/>
                <a:gd name="T13" fmla="*/ 42 h 539"/>
                <a:gd name="T14" fmla="*/ 340 w 1956"/>
                <a:gd name="T15" fmla="*/ 64 h 539"/>
                <a:gd name="T16" fmla="*/ 376 w 1956"/>
                <a:gd name="T17" fmla="*/ 71 h 539"/>
                <a:gd name="T18" fmla="*/ 390 w 1956"/>
                <a:gd name="T19" fmla="*/ 78 h 539"/>
                <a:gd name="T20" fmla="*/ 411 w 1956"/>
                <a:gd name="T21" fmla="*/ 85 h 539"/>
                <a:gd name="T22" fmla="*/ 432 w 1956"/>
                <a:gd name="T23" fmla="*/ 106 h 539"/>
                <a:gd name="T24" fmla="*/ 447 w 1956"/>
                <a:gd name="T25" fmla="*/ 113 h 539"/>
                <a:gd name="T26" fmla="*/ 475 w 1956"/>
                <a:gd name="T27" fmla="*/ 120 h 539"/>
                <a:gd name="T28" fmla="*/ 546 w 1956"/>
                <a:gd name="T29" fmla="*/ 120 h 539"/>
                <a:gd name="T30" fmla="*/ 631 w 1956"/>
                <a:gd name="T31" fmla="*/ 135 h 539"/>
                <a:gd name="T32" fmla="*/ 638 w 1956"/>
                <a:gd name="T33" fmla="*/ 149 h 539"/>
                <a:gd name="T34" fmla="*/ 723 w 1956"/>
                <a:gd name="T35" fmla="*/ 156 h 539"/>
                <a:gd name="T36" fmla="*/ 758 w 1956"/>
                <a:gd name="T37" fmla="*/ 163 h 539"/>
                <a:gd name="T38" fmla="*/ 794 w 1956"/>
                <a:gd name="T39" fmla="*/ 177 h 539"/>
                <a:gd name="T40" fmla="*/ 801 w 1956"/>
                <a:gd name="T41" fmla="*/ 191 h 539"/>
                <a:gd name="T42" fmla="*/ 836 w 1956"/>
                <a:gd name="T43" fmla="*/ 198 h 539"/>
                <a:gd name="T44" fmla="*/ 850 w 1956"/>
                <a:gd name="T45" fmla="*/ 220 h 539"/>
                <a:gd name="T46" fmla="*/ 858 w 1956"/>
                <a:gd name="T47" fmla="*/ 234 h 539"/>
                <a:gd name="T48" fmla="*/ 865 w 1956"/>
                <a:gd name="T49" fmla="*/ 255 h 539"/>
                <a:gd name="T50" fmla="*/ 957 w 1956"/>
                <a:gd name="T51" fmla="*/ 262 h 539"/>
                <a:gd name="T52" fmla="*/ 1006 w 1956"/>
                <a:gd name="T53" fmla="*/ 269 h 539"/>
                <a:gd name="T54" fmla="*/ 1056 w 1956"/>
                <a:gd name="T55" fmla="*/ 269 h 539"/>
                <a:gd name="T56" fmla="*/ 1084 w 1956"/>
                <a:gd name="T57" fmla="*/ 276 h 539"/>
                <a:gd name="T58" fmla="*/ 1091 w 1956"/>
                <a:gd name="T59" fmla="*/ 298 h 539"/>
                <a:gd name="T60" fmla="*/ 1105 w 1956"/>
                <a:gd name="T61" fmla="*/ 305 h 539"/>
                <a:gd name="T62" fmla="*/ 1141 w 1956"/>
                <a:gd name="T63" fmla="*/ 305 h 539"/>
                <a:gd name="T64" fmla="*/ 1155 w 1956"/>
                <a:gd name="T65" fmla="*/ 319 h 539"/>
                <a:gd name="T66" fmla="*/ 1191 w 1956"/>
                <a:gd name="T67" fmla="*/ 326 h 539"/>
                <a:gd name="T68" fmla="*/ 1212 w 1956"/>
                <a:gd name="T69" fmla="*/ 340 h 539"/>
                <a:gd name="T70" fmla="*/ 1254 w 1956"/>
                <a:gd name="T71" fmla="*/ 340 h 539"/>
                <a:gd name="T72" fmla="*/ 1304 w 1956"/>
                <a:gd name="T73" fmla="*/ 347 h 539"/>
                <a:gd name="T74" fmla="*/ 1325 w 1956"/>
                <a:gd name="T75" fmla="*/ 362 h 539"/>
                <a:gd name="T76" fmla="*/ 1410 w 1956"/>
                <a:gd name="T77" fmla="*/ 369 h 539"/>
                <a:gd name="T78" fmla="*/ 1453 w 1956"/>
                <a:gd name="T79" fmla="*/ 369 h 539"/>
                <a:gd name="T80" fmla="*/ 1474 w 1956"/>
                <a:gd name="T81" fmla="*/ 383 h 539"/>
                <a:gd name="T82" fmla="*/ 1524 w 1956"/>
                <a:gd name="T83" fmla="*/ 404 h 539"/>
                <a:gd name="T84" fmla="*/ 1587 w 1956"/>
                <a:gd name="T85" fmla="*/ 404 h 539"/>
                <a:gd name="T86" fmla="*/ 1601 w 1956"/>
                <a:gd name="T87" fmla="*/ 425 h 539"/>
                <a:gd name="T88" fmla="*/ 1616 w 1956"/>
                <a:gd name="T89" fmla="*/ 454 h 539"/>
                <a:gd name="T90" fmla="*/ 1679 w 1956"/>
                <a:gd name="T91" fmla="*/ 468 h 539"/>
                <a:gd name="T92" fmla="*/ 1750 w 1956"/>
                <a:gd name="T93" fmla="*/ 475 h 539"/>
                <a:gd name="T94" fmla="*/ 1772 w 1956"/>
                <a:gd name="T95" fmla="*/ 503 h 539"/>
                <a:gd name="T96" fmla="*/ 1835 w 1956"/>
                <a:gd name="T97" fmla="*/ 518 h 539"/>
                <a:gd name="T98" fmla="*/ 1906 w 1956"/>
                <a:gd name="T99" fmla="*/ 525 h 539"/>
                <a:gd name="T100" fmla="*/ 1942 w 1956"/>
                <a:gd name="T101" fmla="*/ 539 h 5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</a:cxnLst>
              <a:rect l="0" t="0" r="r" b="b"/>
              <a:pathLst>
                <a:path w="1956" h="539">
                  <a:moveTo>
                    <a:pt x="0" y="0"/>
                  </a:moveTo>
                  <a:lnTo>
                    <a:pt x="14" y="0"/>
                  </a:lnTo>
                  <a:lnTo>
                    <a:pt x="14" y="7"/>
                  </a:lnTo>
                  <a:lnTo>
                    <a:pt x="29" y="7"/>
                  </a:lnTo>
                  <a:lnTo>
                    <a:pt x="50" y="7"/>
                  </a:lnTo>
                  <a:lnTo>
                    <a:pt x="71" y="7"/>
                  </a:lnTo>
                  <a:lnTo>
                    <a:pt x="71" y="14"/>
                  </a:lnTo>
                  <a:lnTo>
                    <a:pt x="114" y="14"/>
                  </a:lnTo>
                  <a:lnTo>
                    <a:pt x="135" y="14"/>
                  </a:lnTo>
                  <a:lnTo>
                    <a:pt x="135" y="21"/>
                  </a:lnTo>
                  <a:lnTo>
                    <a:pt x="156" y="21"/>
                  </a:lnTo>
                  <a:lnTo>
                    <a:pt x="156" y="28"/>
                  </a:lnTo>
                  <a:lnTo>
                    <a:pt x="184" y="28"/>
                  </a:lnTo>
                  <a:lnTo>
                    <a:pt x="184" y="35"/>
                  </a:lnTo>
                  <a:lnTo>
                    <a:pt x="199" y="35"/>
                  </a:lnTo>
                  <a:lnTo>
                    <a:pt x="248" y="35"/>
                  </a:lnTo>
                  <a:lnTo>
                    <a:pt x="262" y="35"/>
                  </a:lnTo>
                  <a:lnTo>
                    <a:pt x="291" y="35"/>
                  </a:lnTo>
                  <a:lnTo>
                    <a:pt x="291" y="42"/>
                  </a:lnTo>
                  <a:lnTo>
                    <a:pt x="312" y="42"/>
                  </a:lnTo>
                  <a:lnTo>
                    <a:pt x="333" y="42"/>
                  </a:lnTo>
                  <a:lnTo>
                    <a:pt x="333" y="49"/>
                  </a:lnTo>
                  <a:lnTo>
                    <a:pt x="340" y="49"/>
                  </a:lnTo>
                  <a:lnTo>
                    <a:pt x="340" y="64"/>
                  </a:lnTo>
                  <a:lnTo>
                    <a:pt x="362" y="64"/>
                  </a:lnTo>
                  <a:lnTo>
                    <a:pt x="376" y="64"/>
                  </a:lnTo>
                  <a:lnTo>
                    <a:pt x="376" y="71"/>
                  </a:lnTo>
                  <a:lnTo>
                    <a:pt x="383" y="71"/>
                  </a:lnTo>
                  <a:lnTo>
                    <a:pt x="383" y="78"/>
                  </a:lnTo>
                  <a:lnTo>
                    <a:pt x="390" y="78"/>
                  </a:lnTo>
                  <a:lnTo>
                    <a:pt x="397" y="78"/>
                  </a:lnTo>
                  <a:lnTo>
                    <a:pt x="397" y="85"/>
                  </a:lnTo>
                  <a:lnTo>
                    <a:pt x="411" y="85"/>
                  </a:lnTo>
                  <a:lnTo>
                    <a:pt x="411" y="99"/>
                  </a:lnTo>
                  <a:lnTo>
                    <a:pt x="432" y="99"/>
                  </a:lnTo>
                  <a:lnTo>
                    <a:pt x="432" y="106"/>
                  </a:lnTo>
                  <a:lnTo>
                    <a:pt x="439" y="106"/>
                  </a:lnTo>
                  <a:lnTo>
                    <a:pt x="439" y="113"/>
                  </a:lnTo>
                  <a:lnTo>
                    <a:pt x="447" y="113"/>
                  </a:lnTo>
                  <a:lnTo>
                    <a:pt x="447" y="120"/>
                  </a:lnTo>
                  <a:lnTo>
                    <a:pt x="468" y="120"/>
                  </a:lnTo>
                  <a:lnTo>
                    <a:pt x="475" y="120"/>
                  </a:lnTo>
                  <a:lnTo>
                    <a:pt x="482" y="120"/>
                  </a:lnTo>
                  <a:lnTo>
                    <a:pt x="539" y="120"/>
                  </a:lnTo>
                  <a:lnTo>
                    <a:pt x="546" y="120"/>
                  </a:lnTo>
                  <a:lnTo>
                    <a:pt x="546" y="135"/>
                  </a:lnTo>
                  <a:lnTo>
                    <a:pt x="610" y="135"/>
                  </a:lnTo>
                  <a:lnTo>
                    <a:pt x="631" y="135"/>
                  </a:lnTo>
                  <a:lnTo>
                    <a:pt x="631" y="142"/>
                  </a:lnTo>
                  <a:lnTo>
                    <a:pt x="631" y="149"/>
                  </a:lnTo>
                  <a:lnTo>
                    <a:pt x="638" y="149"/>
                  </a:lnTo>
                  <a:lnTo>
                    <a:pt x="638" y="156"/>
                  </a:lnTo>
                  <a:lnTo>
                    <a:pt x="702" y="156"/>
                  </a:lnTo>
                  <a:lnTo>
                    <a:pt x="723" y="156"/>
                  </a:lnTo>
                  <a:lnTo>
                    <a:pt x="737" y="156"/>
                  </a:lnTo>
                  <a:lnTo>
                    <a:pt x="737" y="163"/>
                  </a:lnTo>
                  <a:lnTo>
                    <a:pt x="758" y="163"/>
                  </a:lnTo>
                  <a:lnTo>
                    <a:pt x="780" y="163"/>
                  </a:lnTo>
                  <a:lnTo>
                    <a:pt x="780" y="177"/>
                  </a:lnTo>
                  <a:lnTo>
                    <a:pt x="794" y="177"/>
                  </a:lnTo>
                  <a:lnTo>
                    <a:pt x="794" y="184"/>
                  </a:lnTo>
                  <a:lnTo>
                    <a:pt x="801" y="184"/>
                  </a:lnTo>
                  <a:lnTo>
                    <a:pt x="801" y="191"/>
                  </a:lnTo>
                  <a:lnTo>
                    <a:pt x="808" y="191"/>
                  </a:lnTo>
                  <a:lnTo>
                    <a:pt x="808" y="198"/>
                  </a:lnTo>
                  <a:lnTo>
                    <a:pt x="836" y="198"/>
                  </a:lnTo>
                  <a:lnTo>
                    <a:pt x="836" y="206"/>
                  </a:lnTo>
                  <a:lnTo>
                    <a:pt x="836" y="220"/>
                  </a:lnTo>
                  <a:lnTo>
                    <a:pt x="850" y="220"/>
                  </a:lnTo>
                  <a:lnTo>
                    <a:pt x="850" y="227"/>
                  </a:lnTo>
                  <a:lnTo>
                    <a:pt x="850" y="234"/>
                  </a:lnTo>
                  <a:lnTo>
                    <a:pt x="858" y="234"/>
                  </a:lnTo>
                  <a:lnTo>
                    <a:pt x="858" y="241"/>
                  </a:lnTo>
                  <a:lnTo>
                    <a:pt x="865" y="241"/>
                  </a:lnTo>
                  <a:lnTo>
                    <a:pt x="865" y="255"/>
                  </a:lnTo>
                  <a:lnTo>
                    <a:pt x="872" y="255"/>
                  </a:lnTo>
                  <a:lnTo>
                    <a:pt x="957" y="255"/>
                  </a:lnTo>
                  <a:lnTo>
                    <a:pt x="957" y="262"/>
                  </a:lnTo>
                  <a:lnTo>
                    <a:pt x="999" y="262"/>
                  </a:lnTo>
                  <a:lnTo>
                    <a:pt x="1006" y="262"/>
                  </a:lnTo>
                  <a:lnTo>
                    <a:pt x="1006" y="269"/>
                  </a:lnTo>
                  <a:lnTo>
                    <a:pt x="1013" y="269"/>
                  </a:lnTo>
                  <a:lnTo>
                    <a:pt x="1028" y="269"/>
                  </a:lnTo>
                  <a:lnTo>
                    <a:pt x="1056" y="269"/>
                  </a:lnTo>
                  <a:lnTo>
                    <a:pt x="1056" y="276"/>
                  </a:lnTo>
                  <a:lnTo>
                    <a:pt x="1063" y="276"/>
                  </a:lnTo>
                  <a:lnTo>
                    <a:pt x="1084" y="276"/>
                  </a:lnTo>
                  <a:lnTo>
                    <a:pt x="1091" y="276"/>
                  </a:lnTo>
                  <a:lnTo>
                    <a:pt x="1091" y="291"/>
                  </a:lnTo>
                  <a:lnTo>
                    <a:pt x="1091" y="298"/>
                  </a:lnTo>
                  <a:lnTo>
                    <a:pt x="1098" y="298"/>
                  </a:lnTo>
                  <a:lnTo>
                    <a:pt x="1105" y="298"/>
                  </a:lnTo>
                  <a:lnTo>
                    <a:pt x="1105" y="305"/>
                  </a:lnTo>
                  <a:lnTo>
                    <a:pt x="1113" y="305"/>
                  </a:lnTo>
                  <a:lnTo>
                    <a:pt x="1120" y="305"/>
                  </a:lnTo>
                  <a:lnTo>
                    <a:pt x="1141" y="305"/>
                  </a:lnTo>
                  <a:lnTo>
                    <a:pt x="1148" y="305"/>
                  </a:lnTo>
                  <a:lnTo>
                    <a:pt x="1155" y="305"/>
                  </a:lnTo>
                  <a:lnTo>
                    <a:pt x="1155" y="319"/>
                  </a:lnTo>
                  <a:lnTo>
                    <a:pt x="1162" y="319"/>
                  </a:lnTo>
                  <a:lnTo>
                    <a:pt x="1162" y="326"/>
                  </a:lnTo>
                  <a:lnTo>
                    <a:pt x="1191" y="326"/>
                  </a:lnTo>
                  <a:lnTo>
                    <a:pt x="1198" y="326"/>
                  </a:lnTo>
                  <a:lnTo>
                    <a:pt x="1198" y="340"/>
                  </a:lnTo>
                  <a:lnTo>
                    <a:pt x="1212" y="340"/>
                  </a:lnTo>
                  <a:lnTo>
                    <a:pt x="1219" y="340"/>
                  </a:lnTo>
                  <a:lnTo>
                    <a:pt x="1226" y="340"/>
                  </a:lnTo>
                  <a:lnTo>
                    <a:pt x="1254" y="340"/>
                  </a:lnTo>
                  <a:lnTo>
                    <a:pt x="1283" y="340"/>
                  </a:lnTo>
                  <a:lnTo>
                    <a:pt x="1283" y="347"/>
                  </a:lnTo>
                  <a:lnTo>
                    <a:pt x="1304" y="347"/>
                  </a:lnTo>
                  <a:lnTo>
                    <a:pt x="1311" y="347"/>
                  </a:lnTo>
                  <a:lnTo>
                    <a:pt x="1325" y="347"/>
                  </a:lnTo>
                  <a:lnTo>
                    <a:pt x="1325" y="362"/>
                  </a:lnTo>
                  <a:lnTo>
                    <a:pt x="1382" y="362"/>
                  </a:lnTo>
                  <a:lnTo>
                    <a:pt x="1410" y="362"/>
                  </a:lnTo>
                  <a:lnTo>
                    <a:pt x="1410" y="369"/>
                  </a:lnTo>
                  <a:lnTo>
                    <a:pt x="1431" y="369"/>
                  </a:lnTo>
                  <a:lnTo>
                    <a:pt x="1431" y="369"/>
                  </a:lnTo>
                  <a:lnTo>
                    <a:pt x="1453" y="369"/>
                  </a:lnTo>
                  <a:lnTo>
                    <a:pt x="1460" y="369"/>
                  </a:lnTo>
                  <a:lnTo>
                    <a:pt x="1460" y="383"/>
                  </a:lnTo>
                  <a:lnTo>
                    <a:pt x="1474" y="383"/>
                  </a:lnTo>
                  <a:lnTo>
                    <a:pt x="1474" y="390"/>
                  </a:lnTo>
                  <a:lnTo>
                    <a:pt x="1524" y="390"/>
                  </a:lnTo>
                  <a:lnTo>
                    <a:pt x="1524" y="404"/>
                  </a:lnTo>
                  <a:lnTo>
                    <a:pt x="1538" y="404"/>
                  </a:lnTo>
                  <a:lnTo>
                    <a:pt x="1580" y="404"/>
                  </a:lnTo>
                  <a:lnTo>
                    <a:pt x="1587" y="404"/>
                  </a:lnTo>
                  <a:lnTo>
                    <a:pt x="1587" y="418"/>
                  </a:lnTo>
                  <a:lnTo>
                    <a:pt x="1587" y="425"/>
                  </a:lnTo>
                  <a:lnTo>
                    <a:pt x="1601" y="425"/>
                  </a:lnTo>
                  <a:lnTo>
                    <a:pt x="1601" y="440"/>
                  </a:lnTo>
                  <a:lnTo>
                    <a:pt x="1616" y="440"/>
                  </a:lnTo>
                  <a:lnTo>
                    <a:pt x="1616" y="454"/>
                  </a:lnTo>
                  <a:lnTo>
                    <a:pt x="1665" y="454"/>
                  </a:lnTo>
                  <a:lnTo>
                    <a:pt x="1679" y="454"/>
                  </a:lnTo>
                  <a:lnTo>
                    <a:pt x="1679" y="468"/>
                  </a:lnTo>
                  <a:lnTo>
                    <a:pt x="1743" y="468"/>
                  </a:lnTo>
                  <a:lnTo>
                    <a:pt x="1743" y="475"/>
                  </a:lnTo>
                  <a:lnTo>
                    <a:pt x="1750" y="475"/>
                  </a:lnTo>
                  <a:lnTo>
                    <a:pt x="1772" y="475"/>
                  </a:lnTo>
                  <a:lnTo>
                    <a:pt x="1772" y="489"/>
                  </a:lnTo>
                  <a:lnTo>
                    <a:pt x="1772" y="503"/>
                  </a:lnTo>
                  <a:lnTo>
                    <a:pt x="1800" y="503"/>
                  </a:lnTo>
                  <a:lnTo>
                    <a:pt x="1835" y="503"/>
                  </a:lnTo>
                  <a:lnTo>
                    <a:pt x="1835" y="518"/>
                  </a:lnTo>
                  <a:lnTo>
                    <a:pt x="1885" y="518"/>
                  </a:lnTo>
                  <a:lnTo>
                    <a:pt x="1885" y="525"/>
                  </a:lnTo>
                  <a:lnTo>
                    <a:pt x="1906" y="525"/>
                  </a:lnTo>
                  <a:lnTo>
                    <a:pt x="1934" y="525"/>
                  </a:lnTo>
                  <a:lnTo>
                    <a:pt x="1942" y="525"/>
                  </a:lnTo>
                  <a:lnTo>
                    <a:pt x="1942" y="539"/>
                  </a:lnTo>
                  <a:lnTo>
                    <a:pt x="1956" y="539"/>
                  </a:lnTo>
                </a:path>
              </a:pathLst>
            </a:custGeom>
            <a:noFill/>
            <a:ln w="190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" name="Freeform 28">
              <a:extLst>
                <a:ext uri="{FF2B5EF4-FFF2-40B4-BE49-F238E27FC236}">
                  <a16:creationId xmlns:a16="http://schemas.microsoft.com/office/drawing/2014/main" id="{AB1080D4-8B5D-45CD-BC60-A37C1FF2C04A}"/>
                </a:ext>
              </a:extLst>
            </p:cNvPr>
            <p:cNvSpPr>
              <a:spLocks/>
            </p:cNvSpPr>
            <p:nvPr/>
          </p:nvSpPr>
          <p:spPr bwMode="auto">
            <a:xfrm>
              <a:off x="1222375" y="858838"/>
              <a:ext cx="3105150" cy="765175"/>
            </a:xfrm>
            <a:custGeom>
              <a:avLst/>
              <a:gdLst>
                <a:gd name="T0" fmla="*/ 0 w 1956"/>
                <a:gd name="T1" fmla="*/ 0 h 482"/>
                <a:gd name="T2" fmla="*/ 489 w 1956"/>
                <a:gd name="T3" fmla="*/ 0 h 482"/>
                <a:gd name="T4" fmla="*/ 489 w 1956"/>
                <a:gd name="T5" fmla="*/ 163 h 482"/>
                <a:gd name="T6" fmla="*/ 765 w 1956"/>
                <a:gd name="T7" fmla="*/ 163 h 482"/>
                <a:gd name="T8" fmla="*/ 765 w 1956"/>
                <a:gd name="T9" fmla="*/ 319 h 482"/>
                <a:gd name="T10" fmla="*/ 772 w 1956"/>
                <a:gd name="T11" fmla="*/ 319 h 482"/>
                <a:gd name="T12" fmla="*/ 772 w 1956"/>
                <a:gd name="T13" fmla="*/ 482 h 482"/>
                <a:gd name="T14" fmla="*/ 1353 w 1956"/>
                <a:gd name="T15" fmla="*/ 482 h 482"/>
                <a:gd name="T16" fmla="*/ 1956 w 1956"/>
                <a:gd name="T17" fmla="*/ 482 h 4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1956" h="482">
                  <a:moveTo>
                    <a:pt x="0" y="0"/>
                  </a:moveTo>
                  <a:lnTo>
                    <a:pt x="489" y="0"/>
                  </a:lnTo>
                  <a:lnTo>
                    <a:pt x="489" y="163"/>
                  </a:lnTo>
                  <a:lnTo>
                    <a:pt x="765" y="163"/>
                  </a:lnTo>
                  <a:lnTo>
                    <a:pt x="765" y="319"/>
                  </a:lnTo>
                  <a:lnTo>
                    <a:pt x="772" y="319"/>
                  </a:lnTo>
                  <a:lnTo>
                    <a:pt x="772" y="482"/>
                  </a:lnTo>
                  <a:lnTo>
                    <a:pt x="1353" y="482"/>
                  </a:lnTo>
                  <a:lnTo>
                    <a:pt x="1956" y="482"/>
                  </a:lnTo>
                </a:path>
              </a:pathLst>
            </a:custGeom>
            <a:noFill/>
            <a:ln w="190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8" name="Line 29">
              <a:extLst>
                <a:ext uri="{FF2B5EF4-FFF2-40B4-BE49-F238E27FC236}">
                  <a16:creationId xmlns:a16="http://schemas.microsoft.com/office/drawing/2014/main" id="{F4653842-0DFD-4FDC-B0BD-D73CFF35DDC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222375" y="858838"/>
              <a:ext cx="0" cy="2027237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Line 30">
              <a:extLst>
                <a:ext uri="{FF2B5EF4-FFF2-40B4-BE49-F238E27FC236}">
                  <a16:creationId xmlns:a16="http://schemas.microsoft.com/office/drawing/2014/main" id="{7680B131-FBB0-4653-806E-385DBF80AB3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222375" y="2886075"/>
              <a:ext cx="3105150" cy="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0" name="Line 31">
              <a:extLst>
                <a:ext uri="{FF2B5EF4-FFF2-40B4-BE49-F238E27FC236}">
                  <a16:creationId xmlns:a16="http://schemas.microsoft.com/office/drawing/2014/main" id="{680BBD73-3DCF-495A-9B24-3C7258C22E4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22375" y="2886075"/>
              <a:ext cx="0" cy="66675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Rectangle 32">
              <a:extLst>
                <a:ext uri="{FF2B5EF4-FFF2-40B4-BE49-F238E27FC236}">
                  <a16:creationId xmlns:a16="http://schemas.microsoft.com/office/drawing/2014/main" id="{8AD90BCD-B224-4111-8394-6D5F8C1E4C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77925" y="2965450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Line 33">
              <a:extLst>
                <a:ext uri="{FF2B5EF4-FFF2-40B4-BE49-F238E27FC236}">
                  <a16:creationId xmlns:a16="http://schemas.microsoft.com/office/drawing/2014/main" id="{C8F466C4-F979-43F4-A754-CB4AD6471EF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38288" y="2886075"/>
              <a:ext cx="0" cy="33337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3" name="Line 34">
              <a:extLst>
                <a:ext uri="{FF2B5EF4-FFF2-40B4-BE49-F238E27FC236}">
                  <a16:creationId xmlns:a16="http://schemas.microsoft.com/office/drawing/2014/main" id="{4C1DA126-438C-4244-88B9-FCB270E0757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41500" y="2886075"/>
              <a:ext cx="0" cy="66675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4" name="Rectangle 35">
              <a:extLst>
                <a:ext uri="{FF2B5EF4-FFF2-40B4-BE49-F238E27FC236}">
                  <a16:creationId xmlns:a16="http://schemas.microsoft.com/office/drawing/2014/main" id="{1C15D835-1CC7-408C-A7FA-19D719F5DA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7050" y="2965450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Line 36">
              <a:extLst>
                <a:ext uri="{FF2B5EF4-FFF2-40B4-BE49-F238E27FC236}">
                  <a16:creationId xmlns:a16="http://schemas.microsoft.com/office/drawing/2014/main" id="{DEB5D3AE-57CC-450B-A9B4-EF22298AABA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55825" y="2886075"/>
              <a:ext cx="0" cy="33337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6" name="Line 37">
              <a:extLst>
                <a:ext uri="{FF2B5EF4-FFF2-40B4-BE49-F238E27FC236}">
                  <a16:creationId xmlns:a16="http://schemas.microsoft.com/office/drawing/2014/main" id="{066BF27D-9EC4-4132-B9D2-F9590936F83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60625" y="2886075"/>
              <a:ext cx="0" cy="66675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4" name="Rectangle 38">
              <a:extLst>
                <a:ext uri="{FF2B5EF4-FFF2-40B4-BE49-F238E27FC236}">
                  <a16:creationId xmlns:a16="http://schemas.microsoft.com/office/drawing/2014/main" id="{87518B0A-A917-46C4-A0EB-876368EFAB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14588" y="2965450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" name="Line 39">
              <a:extLst>
                <a:ext uri="{FF2B5EF4-FFF2-40B4-BE49-F238E27FC236}">
                  <a16:creationId xmlns:a16="http://schemas.microsoft.com/office/drawing/2014/main" id="{B9B35633-8806-4F0B-970F-74E54981FBD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74950" y="2886075"/>
              <a:ext cx="0" cy="33337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6" name="Line 40">
              <a:extLst>
                <a:ext uri="{FF2B5EF4-FFF2-40B4-BE49-F238E27FC236}">
                  <a16:creationId xmlns:a16="http://schemas.microsoft.com/office/drawing/2014/main" id="{03936C8E-BD29-434A-8A89-E9FD8B78F98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89275" y="2886075"/>
              <a:ext cx="0" cy="66675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9" name="Rectangle 41">
              <a:extLst>
                <a:ext uri="{FF2B5EF4-FFF2-40B4-BE49-F238E27FC236}">
                  <a16:creationId xmlns:a16="http://schemas.microsoft.com/office/drawing/2014/main" id="{A1DD83AA-3468-4D82-A75E-B3AC9AE649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44825" y="2965450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3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6" name="Line 42">
              <a:extLst>
                <a:ext uri="{FF2B5EF4-FFF2-40B4-BE49-F238E27FC236}">
                  <a16:creationId xmlns:a16="http://schemas.microsoft.com/office/drawing/2014/main" id="{05EF5640-F12A-486F-8FB6-5A525F209B8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94075" y="2886075"/>
              <a:ext cx="0" cy="33337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7" name="Line 43">
              <a:extLst>
                <a:ext uri="{FF2B5EF4-FFF2-40B4-BE49-F238E27FC236}">
                  <a16:creationId xmlns:a16="http://schemas.microsoft.com/office/drawing/2014/main" id="{567A34B2-A831-47DD-B2D6-84CB5A769C0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08400" y="2886075"/>
              <a:ext cx="0" cy="66675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8" name="Rectangle 44">
              <a:extLst>
                <a:ext uri="{FF2B5EF4-FFF2-40B4-BE49-F238E27FC236}">
                  <a16:creationId xmlns:a16="http://schemas.microsoft.com/office/drawing/2014/main" id="{1CD7EDF9-A883-4DF2-B3A2-9E48973DDB7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63950" y="2965450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4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9" name="Line 45">
              <a:extLst>
                <a:ext uri="{FF2B5EF4-FFF2-40B4-BE49-F238E27FC236}">
                  <a16:creationId xmlns:a16="http://schemas.microsoft.com/office/drawing/2014/main" id="{51C24892-64D7-450D-B891-3CFEFD8D156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11613" y="2886075"/>
              <a:ext cx="0" cy="33337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0" name="Line 46">
              <a:extLst>
                <a:ext uri="{FF2B5EF4-FFF2-40B4-BE49-F238E27FC236}">
                  <a16:creationId xmlns:a16="http://schemas.microsoft.com/office/drawing/2014/main" id="{231EDF96-1576-4E1A-B0D0-6562E1E7509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27525" y="2886075"/>
              <a:ext cx="0" cy="66675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1" name="Rectangle 47">
              <a:extLst>
                <a:ext uri="{FF2B5EF4-FFF2-40B4-BE49-F238E27FC236}">
                  <a16:creationId xmlns:a16="http://schemas.microsoft.com/office/drawing/2014/main" id="{4A4E6496-AE0E-4D61-AEE2-A4104C35A9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81488" y="2965450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5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93" name="グループ化 192">
            <a:extLst>
              <a:ext uri="{FF2B5EF4-FFF2-40B4-BE49-F238E27FC236}">
                <a16:creationId xmlns:a16="http://schemas.microsoft.com/office/drawing/2014/main" id="{B0995E52-262E-419E-A9AC-3265C1C6AD45}"/>
              </a:ext>
            </a:extLst>
          </p:cNvPr>
          <p:cNvGrpSpPr/>
          <p:nvPr/>
        </p:nvGrpSpPr>
        <p:grpSpPr>
          <a:xfrm>
            <a:off x="5056188" y="956559"/>
            <a:ext cx="3440981" cy="2423657"/>
            <a:chOff x="5659438" y="854075"/>
            <a:chExt cx="3440981" cy="2423657"/>
          </a:xfrm>
        </p:grpSpPr>
        <p:sp>
          <p:nvSpPr>
            <p:cNvPr id="149" name="Line 54">
              <a:extLst>
                <a:ext uri="{FF2B5EF4-FFF2-40B4-BE49-F238E27FC236}">
                  <a16:creationId xmlns:a16="http://schemas.microsoft.com/office/drawing/2014/main" id="{7EAFA133-1CBE-4D48-8EA0-5B04D7D9140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884863" y="2982913"/>
              <a:ext cx="66675" cy="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0" name="Rectangle 55">
              <a:extLst>
                <a:ext uri="{FF2B5EF4-FFF2-40B4-BE49-F238E27FC236}">
                  <a16:creationId xmlns:a16="http://schemas.microsoft.com/office/drawing/2014/main" id="{C6200819-43D9-476E-8281-1F2CB792A7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59438" y="2881313"/>
              <a:ext cx="22442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0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1" name="Line 56">
              <a:extLst>
                <a:ext uri="{FF2B5EF4-FFF2-40B4-BE49-F238E27FC236}">
                  <a16:creationId xmlns:a16="http://schemas.microsoft.com/office/drawing/2014/main" id="{F4B85E40-912C-4AE0-97F3-330CEA09C18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918201" y="2779713"/>
              <a:ext cx="33338" cy="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2" name="Line 57">
              <a:extLst>
                <a:ext uri="{FF2B5EF4-FFF2-40B4-BE49-F238E27FC236}">
                  <a16:creationId xmlns:a16="http://schemas.microsoft.com/office/drawing/2014/main" id="{B4E5F356-CA3F-4814-98AE-31F1DAA8373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884863" y="2576513"/>
              <a:ext cx="66675" cy="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3" name="Rectangle 58">
              <a:extLst>
                <a:ext uri="{FF2B5EF4-FFF2-40B4-BE49-F238E27FC236}">
                  <a16:creationId xmlns:a16="http://schemas.microsoft.com/office/drawing/2014/main" id="{39C1F1C5-E4AC-4D07-A38F-AA8A1D4CC9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59438" y="2476500"/>
              <a:ext cx="22442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2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4" name="Line 59">
              <a:extLst>
                <a:ext uri="{FF2B5EF4-FFF2-40B4-BE49-F238E27FC236}">
                  <a16:creationId xmlns:a16="http://schemas.microsoft.com/office/drawing/2014/main" id="{DB2C17A0-36EC-46F4-84DB-2709B831E61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918201" y="2374900"/>
              <a:ext cx="33338" cy="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5" name="Line 60">
              <a:extLst>
                <a:ext uri="{FF2B5EF4-FFF2-40B4-BE49-F238E27FC236}">
                  <a16:creationId xmlns:a16="http://schemas.microsoft.com/office/drawing/2014/main" id="{A0A1B73C-A476-4984-A182-7C7C4DE8114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884863" y="2171700"/>
              <a:ext cx="66675" cy="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6" name="Rectangle 61">
              <a:extLst>
                <a:ext uri="{FF2B5EF4-FFF2-40B4-BE49-F238E27FC236}">
                  <a16:creationId xmlns:a16="http://schemas.microsoft.com/office/drawing/2014/main" id="{9DE90382-E681-4417-AD23-C4FAFCAE2A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59438" y="2070100"/>
              <a:ext cx="22442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4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7" name="Line 62">
              <a:extLst>
                <a:ext uri="{FF2B5EF4-FFF2-40B4-BE49-F238E27FC236}">
                  <a16:creationId xmlns:a16="http://schemas.microsoft.com/office/drawing/2014/main" id="{04D2F1DF-5E08-4095-A8D1-15875F87D7D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918201" y="1968500"/>
              <a:ext cx="33338" cy="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8" name="Line 63">
              <a:extLst>
                <a:ext uri="{FF2B5EF4-FFF2-40B4-BE49-F238E27FC236}">
                  <a16:creationId xmlns:a16="http://schemas.microsoft.com/office/drawing/2014/main" id="{DAEBDBDF-AFA0-4748-8380-B2F887B0846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884863" y="1766888"/>
              <a:ext cx="66675" cy="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9" name="Rectangle 64">
              <a:extLst>
                <a:ext uri="{FF2B5EF4-FFF2-40B4-BE49-F238E27FC236}">
                  <a16:creationId xmlns:a16="http://schemas.microsoft.com/office/drawing/2014/main" id="{156F1152-68FF-4DC7-9471-2B64F8C60C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59438" y="1665288"/>
              <a:ext cx="22442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6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" name="Line 65">
              <a:extLst>
                <a:ext uri="{FF2B5EF4-FFF2-40B4-BE49-F238E27FC236}">
                  <a16:creationId xmlns:a16="http://schemas.microsoft.com/office/drawing/2014/main" id="{D0575D4E-F49A-4B0E-8AB9-F330C10FA8C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918201" y="1563688"/>
              <a:ext cx="33338" cy="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" name="Line 66">
              <a:extLst>
                <a:ext uri="{FF2B5EF4-FFF2-40B4-BE49-F238E27FC236}">
                  <a16:creationId xmlns:a16="http://schemas.microsoft.com/office/drawing/2014/main" id="{9C8E0388-5486-4934-BCC3-8D93EB8B899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884863" y="1360488"/>
              <a:ext cx="66675" cy="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" name="Rectangle 67">
              <a:extLst>
                <a:ext uri="{FF2B5EF4-FFF2-40B4-BE49-F238E27FC236}">
                  <a16:creationId xmlns:a16="http://schemas.microsoft.com/office/drawing/2014/main" id="{10E2CCCF-AC01-4181-8F8C-877419C9CE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59438" y="1260475"/>
              <a:ext cx="22442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8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" name="Line 68">
              <a:extLst>
                <a:ext uri="{FF2B5EF4-FFF2-40B4-BE49-F238E27FC236}">
                  <a16:creationId xmlns:a16="http://schemas.microsoft.com/office/drawing/2014/main" id="{1DDDF50D-4C3B-4FDF-9E47-8908F50F5A9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918201" y="1157288"/>
              <a:ext cx="33338" cy="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4" name="Line 69">
              <a:extLst>
                <a:ext uri="{FF2B5EF4-FFF2-40B4-BE49-F238E27FC236}">
                  <a16:creationId xmlns:a16="http://schemas.microsoft.com/office/drawing/2014/main" id="{AD7BBDAD-414C-4AD0-BB67-1B77FDD3B75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884863" y="955675"/>
              <a:ext cx="66675" cy="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5" name="Rectangle 70">
              <a:extLst>
                <a:ext uri="{FF2B5EF4-FFF2-40B4-BE49-F238E27FC236}">
                  <a16:creationId xmlns:a16="http://schemas.microsoft.com/office/drawing/2014/main" id="{88703E07-D12D-4A88-8D7C-D5B15E053A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59438" y="854075"/>
              <a:ext cx="22442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.0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0" name="Freeform 75">
              <a:extLst>
                <a:ext uri="{FF2B5EF4-FFF2-40B4-BE49-F238E27FC236}">
                  <a16:creationId xmlns:a16="http://schemas.microsoft.com/office/drawing/2014/main" id="{CB9BD9C2-FBFE-4471-A4E4-CB68684FEA05}"/>
                </a:ext>
              </a:extLst>
            </p:cNvPr>
            <p:cNvSpPr>
              <a:spLocks/>
            </p:cNvSpPr>
            <p:nvPr/>
          </p:nvSpPr>
          <p:spPr bwMode="auto">
            <a:xfrm>
              <a:off x="5951538" y="955675"/>
              <a:ext cx="3105150" cy="1554163"/>
            </a:xfrm>
            <a:custGeom>
              <a:avLst/>
              <a:gdLst>
                <a:gd name="T0" fmla="*/ 14 w 1956"/>
                <a:gd name="T1" fmla="*/ 7 h 979"/>
                <a:gd name="T2" fmla="*/ 36 w 1956"/>
                <a:gd name="T3" fmla="*/ 28 h 979"/>
                <a:gd name="T4" fmla="*/ 43 w 1956"/>
                <a:gd name="T5" fmla="*/ 57 h 979"/>
                <a:gd name="T6" fmla="*/ 64 w 1956"/>
                <a:gd name="T7" fmla="*/ 78 h 979"/>
                <a:gd name="T8" fmla="*/ 71 w 1956"/>
                <a:gd name="T9" fmla="*/ 106 h 979"/>
                <a:gd name="T10" fmla="*/ 78 w 1956"/>
                <a:gd name="T11" fmla="*/ 127 h 979"/>
                <a:gd name="T12" fmla="*/ 85 w 1956"/>
                <a:gd name="T13" fmla="*/ 156 h 979"/>
                <a:gd name="T14" fmla="*/ 99 w 1956"/>
                <a:gd name="T15" fmla="*/ 170 h 979"/>
                <a:gd name="T16" fmla="*/ 99 w 1956"/>
                <a:gd name="T17" fmla="*/ 220 h 979"/>
                <a:gd name="T18" fmla="*/ 106 w 1956"/>
                <a:gd name="T19" fmla="*/ 241 h 979"/>
                <a:gd name="T20" fmla="*/ 114 w 1956"/>
                <a:gd name="T21" fmla="*/ 262 h 979"/>
                <a:gd name="T22" fmla="*/ 121 w 1956"/>
                <a:gd name="T23" fmla="*/ 298 h 979"/>
                <a:gd name="T24" fmla="*/ 135 w 1956"/>
                <a:gd name="T25" fmla="*/ 312 h 979"/>
                <a:gd name="T26" fmla="*/ 149 w 1956"/>
                <a:gd name="T27" fmla="*/ 326 h 979"/>
                <a:gd name="T28" fmla="*/ 163 w 1956"/>
                <a:gd name="T29" fmla="*/ 369 h 979"/>
                <a:gd name="T30" fmla="*/ 177 w 1956"/>
                <a:gd name="T31" fmla="*/ 390 h 979"/>
                <a:gd name="T32" fmla="*/ 192 w 1956"/>
                <a:gd name="T33" fmla="*/ 411 h 979"/>
                <a:gd name="T34" fmla="*/ 206 w 1956"/>
                <a:gd name="T35" fmla="*/ 425 h 979"/>
                <a:gd name="T36" fmla="*/ 227 w 1956"/>
                <a:gd name="T37" fmla="*/ 440 h 979"/>
                <a:gd name="T38" fmla="*/ 227 w 1956"/>
                <a:gd name="T39" fmla="*/ 468 h 979"/>
                <a:gd name="T40" fmla="*/ 241 w 1956"/>
                <a:gd name="T41" fmla="*/ 482 h 979"/>
                <a:gd name="T42" fmla="*/ 262 w 1956"/>
                <a:gd name="T43" fmla="*/ 503 h 979"/>
                <a:gd name="T44" fmla="*/ 284 w 1956"/>
                <a:gd name="T45" fmla="*/ 518 h 979"/>
                <a:gd name="T46" fmla="*/ 298 w 1956"/>
                <a:gd name="T47" fmla="*/ 539 h 979"/>
                <a:gd name="T48" fmla="*/ 319 w 1956"/>
                <a:gd name="T49" fmla="*/ 567 h 979"/>
                <a:gd name="T50" fmla="*/ 326 w 1956"/>
                <a:gd name="T51" fmla="*/ 596 h 979"/>
                <a:gd name="T52" fmla="*/ 340 w 1956"/>
                <a:gd name="T53" fmla="*/ 610 h 979"/>
                <a:gd name="T54" fmla="*/ 369 w 1956"/>
                <a:gd name="T55" fmla="*/ 631 h 979"/>
                <a:gd name="T56" fmla="*/ 390 w 1956"/>
                <a:gd name="T57" fmla="*/ 645 h 979"/>
                <a:gd name="T58" fmla="*/ 432 w 1956"/>
                <a:gd name="T59" fmla="*/ 660 h 979"/>
                <a:gd name="T60" fmla="*/ 461 w 1956"/>
                <a:gd name="T61" fmla="*/ 681 h 979"/>
                <a:gd name="T62" fmla="*/ 482 w 1956"/>
                <a:gd name="T63" fmla="*/ 695 h 979"/>
                <a:gd name="T64" fmla="*/ 517 w 1956"/>
                <a:gd name="T65" fmla="*/ 709 h 979"/>
                <a:gd name="T66" fmla="*/ 539 w 1956"/>
                <a:gd name="T67" fmla="*/ 731 h 979"/>
                <a:gd name="T68" fmla="*/ 631 w 1956"/>
                <a:gd name="T69" fmla="*/ 745 h 979"/>
                <a:gd name="T70" fmla="*/ 822 w 1956"/>
                <a:gd name="T71" fmla="*/ 766 h 979"/>
                <a:gd name="T72" fmla="*/ 865 w 1956"/>
                <a:gd name="T73" fmla="*/ 780 h 979"/>
                <a:gd name="T74" fmla="*/ 978 w 1956"/>
                <a:gd name="T75" fmla="*/ 794 h 979"/>
                <a:gd name="T76" fmla="*/ 1028 w 1956"/>
                <a:gd name="T77" fmla="*/ 816 h 979"/>
                <a:gd name="T78" fmla="*/ 1098 w 1956"/>
                <a:gd name="T79" fmla="*/ 837 h 979"/>
                <a:gd name="T80" fmla="*/ 1134 w 1956"/>
                <a:gd name="T81" fmla="*/ 858 h 979"/>
                <a:gd name="T82" fmla="*/ 1268 w 1956"/>
                <a:gd name="T83" fmla="*/ 865 h 979"/>
                <a:gd name="T84" fmla="*/ 1353 w 1956"/>
                <a:gd name="T85" fmla="*/ 887 h 979"/>
                <a:gd name="T86" fmla="*/ 1431 w 1956"/>
                <a:gd name="T87" fmla="*/ 901 h 979"/>
                <a:gd name="T88" fmla="*/ 1516 w 1956"/>
                <a:gd name="T89" fmla="*/ 922 h 979"/>
                <a:gd name="T90" fmla="*/ 1722 w 1956"/>
                <a:gd name="T91" fmla="*/ 943 h 979"/>
                <a:gd name="T92" fmla="*/ 1849 w 1956"/>
                <a:gd name="T93" fmla="*/ 958 h 979"/>
                <a:gd name="T94" fmla="*/ 1934 w 1956"/>
                <a:gd name="T95" fmla="*/ 979 h 9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</a:cxnLst>
              <a:rect l="0" t="0" r="r" b="b"/>
              <a:pathLst>
                <a:path w="1956" h="979">
                  <a:moveTo>
                    <a:pt x="0" y="0"/>
                  </a:moveTo>
                  <a:lnTo>
                    <a:pt x="0" y="0"/>
                  </a:lnTo>
                  <a:lnTo>
                    <a:pt x="0" y="7"/>
                  </a:lnTo>
                  <a:lnTo>
                    <a:pt x="14" y="7"/>
                  </a:lnTo>
                  <a:lnTo>
                    <a:pt x="14" y="14"/>
                  </a:lnTo>
                  <a:lnTo>
                    <a:pt x="29" y="14"/>
                  </a:lnTo>
                  <a:lnTo>
                    <a:pt x="29" y="28"/>
                  </a:lnTo>
                  <a:lnTo>
                    <a:pt x="36" y="28"/>
                  </a:lnTo>
                  <a:lnTo>
                    <a:pt x="36" y="42"/>
                  </a:lnTo>
                  <a:lnTo>
                    <a:pt x="43" y="42"/>
                  </a:lnTo>
                  <a:lnTo>
                    <a:pt x="43" y="49"/>
                  </a:lnTo>
                  <a:lnTo>
                    <a:pt x="43" y="57"/>
                  </a:lnTo>
                  <a:lnTo>
                    <a:pt x="50" y="57"/>
                  </a:lnTo>
                  <a:lnTo>
                    <a:pt x="50" y="64"/>
                  </a:lnTo>
                  <a:lnTo>
                    <a:pt x="50" y="78"/>
                  </a:lnTo>
                  <a:lnTo>
                    <a:pt x="64" y="78"/>
                  </a:lnTo>
                  <a:lnTo>
                    <a:pt x="64" y="85"/>
                  </a:lnTo>
                  <a:lnTo>
                    <a:pt x="64" y="99"/>
                  </a:lnTo>
                  <a:lnTo>
                    <a:pt x="71" y="99"/>
                  </a:lnTo>
                  <a:lnTo>
                    <a:pt x="71" y="106"/>
                  </a:lnTo>
                  <a:lnTo>
                    <a:pt x="71" y="113"/>
                  </a:lnTo>
                  <a:lnTo>
                    <a:pt x="71" y="120"/>
                  </a:lnTo>
                  <a:lnTo>
                    <a:pt x="78" y="120"/>
                  </a:lnTo>
                  <a:lnTo>
                    <a:pt x="78" y="127"/>
                  </a:lnTo>
                  <a:lnTo>
                    <a:pt x="78" y="142"/>
                  </a:lnTo>
                  <a:lnTo>
                    <a:pt x="85" y="142"/>
                  </a:lnTo>
                  <a:lnTo>
                    <a:pt x="85" y="149"/>
                  </a:lnTo>
                  <a:lnTo>
                    <a:pt x="85" y="156"/>
                  </a:lnTo>
                  <a:lnTo>
                    <a:pt x="92" y="156"/>
                  </a:lnTo>
                  <a:lnTo>
                    <a:pt x="92" y="163"/>
                  </a:lnTo>
                  <a:lnTo>
                    <a:pt x="92" y="170"/>
                  </a:lnTo>
                  <a:lnTo>
                    <a:pt x="99" y="170"/>
                  </a:lnTo>
                  <a:lnTo>
                    <a:pt x="99" y="177"/>
                  </a:lnTo>
                  <a:lnTo>
                    <a:pt x="99" y="198"/>
                  </a:lnTo>
                  <a:lnTo>
                    <a:pt x="99" y="206"/>
                  </a:lnTo>
                  <a:lnTo>
                    <a:pt x="99" y="220"/>
                  </a:lnTo>
                  <a:lnTo>
                    <a:pt x="99" y="227"/>
                  </a:lnTo>
                  <a:lnTo>
                    <a:pt x="106" y="227"/>
                  </a:lnTo>
                  <a:lnTo>
                    <a:pt x="106" y="234"/>
                  </a:lnTo>
                  <a:lnTo>
                    <a:pt x="106" y="241"/>
                  </a:lnTo>
                  <a:lnTo>
                    <a:pt x="114" y="241"/>
                  </a:lnTo>
                  <a:lnTo>
                    <a:pt x="114" y="248"/>
                  </a:lnTo>
                  <a:lnTo>
                    <a:pt x="114" y="255"/>
                  </a:lnTo>
                  <a:lnTo>
                    <a:pt x="114" y="262"/>
                  </a:lnTo>
                  <a:lnTo>
                    <a:pt x="121" y="262"/>
                  </a:lnTo>
                  <a:lnTo>
                    <a:pt x="121" y="269"/>
                  </a:lnTo>
                  <a:lnTo>
                    <a:pt x="121" y="291"/>
                  </a:lnTo>
                  <a:lnTo>
                    <a:pt x="121" y="298"/>
                  </a:lnTo>
                  <a:lnTo>
                    <a:pt x="128" y="298"/>
                  </a:lnTo>
                  <a:lnTo>
                    <a:pt x="128" y="305"/>
                  </a:lnTo>
                  <a:lnTo>
                    <a:pt x="128" y="312"/>
                  </a:lnTo>
                  <a:lnTo>
                    <a:pt x="135" y="312"/>
                  </a:lnTo>
                  <a:lnTo>
                    <a:pt x="135" y="319"/>
                  </a:lnTo>
                  <a:lnTo>
                    <a:pt x="142" y="319"/>
                  </a:lnTo>
                  <a:lnTo>
                    <a:pt x="142" y="326"/>
                  </a:lnTo>
                  <a:lnTo>
                    <a:pt x="149" y="326"/>
                  </a:lnTo>
                  <a:lnTo>
                    <a:pt x="149" y="340"/>
                  </a:lnTo>
                  <a:lnTo>
                    <a:pt x="163" y="340"/>
                  </a:lnTo>
                  <a:lnTo>
                    <a:pt x="163" y="347"/>
                  </a:lnTo>
                  <a:lnTo>
                    <a:pt x="163" y="369"/>
                  </a:lnTo>
                  <a:lnTo>
                    <a:pt x="170" y="369"/>
                  </a:lnTo>
                  <a:lnTo>
                    <a:pt x="170" y="383"/>
                  </a:lnTo>
                  <a:lnTo>
                    <a:pt x="170" y="390"/>
                  </a:lnTo>
                  <a:lnTo>
                    <a:pt x="177" y="390"/>
                  </a:lnTo>
                  <a:lnTo>
                    <a:pt x="177" y="397"/>
                  </a:lnTo>
                  <a:lnTo>
                    <a:pt x="177" y="404"/>
                  </a:lnTo>
                  <a:lnTo>
                    <a:pt x="192" y="404"/>
                  </a:lnTo>
                  <a:lnTo>
                    <a:pt x="192" y="411"/>
                  </a:lnTo>
                  <a:lnTo>
                    <a:pt x="199" y="411"/>
                  </a:lnTo>
                  <a:lnTo>
                    <a:pt x="199" y="418"/>
                  </a:lnTo>
                  <a:lnTo>
                    <a:pt x="199" y="425"/>
                  </a:lnTo>
                  <a:lnTo>
                    <a:pt x="206" y="425"/>
                  </a:lnTo>
                  <a:lnTo>
                    <a:pt x="213" y="425"/>
                  </a:lnTo>
                  <a:lnTo>
                    <a:pt x="213" y="433"/>
                  </a:lnTo>
                  <a:lnTo>
                    <a:pt x="227" y="433"/>
                  </a:lnTo>
                  <a:lnTo>
                    <a:pt x="227" y="440"/>
                  </a:lnTo>
                  <a:lnTo>
                    <a:pt x="227" y="440"/>
                  </a:lnTo>
                  <a:lnTo>
                    <a:pt x="227" y="447"/>
                  </a:lnTo>
                  <a:lnTo>
                    <a:pt x="227" y="454"/>
                  </a:lnTo>
                  <a:lnTo>
                    <a:pt x="227" y="468"/>
                  </a:lnTo>
                  <a:lnTo>
                    <a:pt x="234" y="468"/>
                  </a:lnTo>
                  <a:lnTo>
                    <a:pt x="234" y="475"/>
                  </a:lnTo>
                  <a:lnTo>
                    <a:pt x="241" y="475"/>
                  </a:lnTo>
                  <a:lnTo>
                    <a:pt x="241" y="482"/>
                  </a:lnTo>
                  <a:lnTo>
                    <a:pt x="241" y="489"/>
                  </a:lnTo>
                  <a:lnTo>
                    <a:pt x="241" y="496"/>
                  </a:lnTo>
                  <a:lnTo>
                    <a:pt x="262" y="496"/>
                  </a:lnTo>
                  <a:lnTo>
                    <a:pt x="262" y="503"/>
                  </a:lnTo>
                  <a:lnTo>
                    <a:pt x="269" y="503"/>
                  </a:lnTo>
                  <a:lnTo>
                    <a:pt x="269" y="511"/>
                  </a:lnTo>
                  <a:lnTo>
                    <a:pt x="269" y="518"/>
                  </a:lnTo>
                  <a:lnTo>
                    <a:pt x="284" y="518"/>
                  </a:lnTo>
                  <a:lnTo>
                    <a:pt x="284" y="525"/>
                  </a:lnTo>
                  <a:lnTo>
                    <a:pt x="298" y="525"/>
                  </a:lnTo>
                  <a:lnTo>
                    <a:pt x="298" y="532"/>
                  </a:lnTo>
                  <a:lnTo>
                    <a:pt x="298" y="539"/>
                  </a:lnTo>
                  <a:lnTo>
                    <a:pt x="298" y="553"/>
                  </a:lnTo>
                  <a:lnTo>
                    <a:pt x="305" y="553"/>
                  </a:lnTo>
                  <a:lnTo>
                    <a:pt x="305" y="567"/>
                  </a:lnTo>
                  <a:lnTo>
                    <a:pt x="319" y="567"/>
                  </a:lnTo>
                  <a:lnTo>
                    <a:pt x="319" y="582"/>
                  </a:lnTo>
                  <a:lnTo>
                    <a:pt x="319" y="589"/>
                  </a:lnTo>
                  <a:lnTo>
                    <a:pt x="326" y="589"/>
                  </a:lnTo>
                  <a:lnTo>
                    <a:pt x="326" y="596"/>
                  </a:lnTo>
                  <a:lnTo>
                    <a:pt x="326" y="603"/>
                  </a:lnTo>
                  <a:lnTo>
                    <a:pt x="333" y="603"/>
                  </a:lnTo>
                  <a:lnTo>
                    <a:pt x="333" y="610"/>
                  </a:lnTo>
                  <a:lnTo>
                    <a:pt x="340" y="610"/>
                  </a:lnTo>
                  <a:lnTo>
                    <a:pt x="340" y="617"/>
                  </a:lnTo>
                  <a:lnTo>
                    <a:pt x="362" y="617"/>
                  </a:lnTo>
                  <a:lnTo>
                    <a:pt x="362" y="631"/>
                  </a:lnTo>
                  <a:lnTo>
                    <a:pt x="369" y="631"/>
                  </a:lnTo>
                  <a:lnTo>
                    <a:pt x="376" y="631"/>
                  </a:lnTo>
                  <a:lnTo>
                    <a:pt x="376" y="638"/>
                  </a:lnTo>
                  <a:lnTo>
                    <a:pt x="390" y="638"/>
                  </a:lnTo>
                  <a:lnTo>
                    <a:pt x="390" y="645"/>
                  </a:lnTo>
                  <a:lnTo>
                    <a:pt x="397" y="645"/>
                  </a:lnTo>
                  <a:lnTo>
                    <a:pt x="397" y="652"/>
                  </a:lnTo>
                  <a:lnTo>
                    <a:pt x="432" y="652"/>
                  </a:lnTo>
                  <a:lnTo>
                    <a:pt x="432" y="660"/>
                  </a:lnTo>
                  <a:lnTo>
                    <a:pt x="439" y="660"/>
                  </a:lnTo>
                  <a:lnTo>
                    <a:pt x="439" y="667"/>
                  </a:lnTo>
                  <a:lnTo>
                    <a:pt x="461" y="667"/>
                  </a:lnTo>
                  <a:lnTo>
                    <a:pt x="461" y="681"/>
                  </a:lnTo>
                  <a:lnTo>
                    <a:pt x="468" y="681"/>
                  </a:lnTo>
                  <a:lnTo>
                    <a:pt x="482" y="681"/>
                  </a:lnTo>
                  <a:lnTo>
                    <a:pt x="482" y="688"/>
                  </a:lnTo>
                  <a:lnTo>
                    <a:pt x="482" y="695"/>
                  </a:lnTo>
                  <a:lnTo>
                    <a:pt x="489" y="695"/>
                  </a:lnTo>
                  <a:lnTo>
                    <a:pt x="489" y="702"/>
                  </a:lnTo>
                  <a:lnTo>
                    <a:pt x="517" y="702"/>
                  </a:lnTo>
                  <a:lnTo>
                    <a:pt x="517" y="709"/>
                  </a:lnTo>
                  <a:lnTo>
                    <a:pt x="525" y="709"/>
                  </a:lnTo>
                  <a:lnTo>
                    <a:pt x="525" y="723"/>
                  </a:lnTo>
                  <a:lnTo>
                    <a:pt x="539" y="723"/>
                  </a:lnTo>
                  <a:lnTo>
                    <a:pt x="539" y="731"/>
                  </a:lnTo>
                  <a:lnTo>
                    <a:pt x="617" y="731"/>
                  </a:lnTo>
                  <a:lnTo>
                    <a:pt x="617" y="738"/>
                  </a:lnTo>
                  <a:lnTo>
                    <a:pt x="631" y="738"/>
                  </a:lnTo>
                  <a:lnTo>
                    <a:pt x="631" y="745"/>
                  </a:lnTo>
                  <a:lnTo>
                    <a:pt x="638" y="745"/>
                  </a:lnTo>
                  <a:lnTo>
                    <a:pt x="638" y="759"/>
                  </a:lnTo>
                  <a:lnTo>
                    <a:pt x="822" y="759"/>
                  </a:lnTo>
                  <a:lnTo>
                    <a:pt x="822" y="766"/>
                  </a:lnTo>
                  <a:lnTo>
                    <a:pt x="850" y="766"/>
                  </a:lnTo>
                  <a:lnTo>
                    <a:pt x="850" y="773"/>
                  </a:lnTo>
                  <a:lnTo>
                    <a:pt x="865" y="773"/>
                  </a:lnTo>
                  <a:lnTo>
                    <a:pt x="865" y="780"/>
                  </a:lnTo>
                  <a:lnTo>
                    <a:pt x="872" y="780"/>
                  </a:lnTo>
                  <a:lnTo>
                    <a:pt x="886" y="780"/>
                  </a:lnTo>
                  <a:lnTo>
                    <a:pt x="886" y="794"/>
                  </a:lnTo>
                  <a:lnTo>
                    <a:pt x="978" y="794"/>
                  </a:lnTo>
                  <a:lnTo>
                    <a:pt x="978" y="801"/>
                  </a:lnTo>
                  <a:lnTo>
                    <a:pt x="1006" y="801"/>
                  </a:lnTo>
                  <a:lnTo>
                    <a:pt x="1006" y="816"/>
                  </a:lnTo>
                  <a:lnTo>
                    <a:pt x="1028" y="816"/>
                  </a:lnTo>
                  <a:lnTo>
                    <a:pt x="1028" y="830"/>
                  </a:lnTo>
                  <a:lnTo>
                    <a:pt x="1084" y="830"/>
                  </a:lnTo>
                  <a:lnTo>
                    <a:pt x="1098" y="830"/>
                  </a:lnTo>
                  <a:lnTo>
                    <a:pt x="1098" y="837"/>
                  </a:lnTo>
                  <a:lnTo>
                    <a:pt x="1113" y="837"/>
                  </a:lnTo>
                  <a:lnTo>
                    <a:pt x="1113" y="844"/>
                  </a:lnTo>
                  <a:lnTo>
                    <a:pt x="1134" y="844"/>
                  </a:lnTo>
                  <a:lnTo>
                    <a:pt x="1134" y="858"/>
                  </a:lnTo>
                  <a:lnTo>
                    <a:pt x="1176" y="858"/>
                  </a:lnTo>
                  <a:lnTo>
                    <a:pt x="1176" y="865"/>
                  </a:lnTo>
                  <a:lnTo>
                    <a:pt x="1226" y="865"/>
                  </a:lnTo>
                  <a:lnTo>
                    <a:pt x="1268" y="865"/>
                  </a:lnTo>
                  <a:lnTo>
                    <a:pt x="1268" y="872"/>
                  </a:lnTo>
                  <a:lnTo>
                    <a:pt x="1304" y="872"/>
                  </a:lnTo>
                  <a:lnTo>
                    <a:pt x="1353" y="872"/>
                  </a:lnTo>
                  <a:lnTo>
                    <a:pt x="1353" y="887"/>
                  </a:lnTo>
                  <a:lnTo>
                    <a:pt x="1375" y="887"/>
                  </a:lnTo>
                  <a:lnTo>
                    <a:pt x="1375" y="894"/>
                  </a:lnTo>
                  <a:lnTo>
                    <a:pt x="1375" y="901"/>
                  </a:lnTo>
                  <a:lnTo>
                    <a:pt x="1431" y="901"/>
                  </a:lnTo>
                  <a:lnTo>
                    <a:pt x="1460" y="901"/>
                  </a:lnTo>
                  <a:lnTo>
                    <a:pt x="1460" y="915"/>
                  </a:lnTo>
                  <a:lnTo>
                    <a:pt x="1516" y="915"/>
                  </a:lnTo>
                  <a:lnTo>
                    <a:pt x="1516" y="922"/>
                  </a:lnTo>
                  <a:lnTo>
                    <a:pt x="1587" y="922"/>
                  </a:lnTo>
                  <a:lnTo>
                    <a:pt x="1587" y="936"/>
                  </a:lnTo>
                  <a:lnTo>
                    <a:pt x="1722" y="936"/>
                  </a:lnTo>
                  <a:lnTo>
                    <a:pt x="1722" y="943"/>
                  </a:lnTo>
                  <a:lnTo>
                    <a:pt x="1750" y="943"/>
                  </a:lnTo>
                  <a:lnTo>
                    <a:pt x="1821" y="943"/>
                  </a:lnTo>
                  <a:lnTo>
                    <a:pt x="1821" y="958"/>
                  </a:lnTo>
                  <a:lnTo>
                    <a:pt x="1849" y="958"/>
                  </a:lnTo>
                  <a:lnTo>
                    <a:pt x="1849" y="965"/>
                  </a:lnTo>
                  <a:lnTo>
                    <a:pt x="1906" y="965"/>
                  </a:lnTo>
                  <a:lnTo>
                    <a:pt x="1934" y="965"/>
                  </a:lnTo>
                  <a:lnTo>
                    <a:pt x="1934" y="979"/>
                  </a:lnTo>
                  <a:lnTo>
                    <a:pt x="1956" y="979"/>
                  </a:lnTo>
                </a:path>
              </a:pathLst>
            </a:custGeom>
            <a:noFill/>
            <a:ln w="190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1" name="Freeform 76">
              <a:extLst>
                <a:ext uri="{FF2B5EF4-FFF2-40B4-BE49-F238E27FC236}">
                  <a16:creationId xmlns:a16="http://schemas.microsoft.com/office/drawing/2014/main" id="{601169C5-DDF1-4DA9-A45A-3587077E1020}"/>
                </a:ext>
              </a:extLst>
            </p:cNvPr>
            <p:cNvSpPr>
              <a:spLocks/>
            </p:cNvSpPr>
            <p:nvPr/>
          </p:nvSpPr>
          <p:spPr bwMode="auto">
            <a:xfrm>
              <a:off x="5951538" y="955675"/>
              <a:ext cx="3105150" cy="1779588"/>
            </a:xfrm>
            <a:custGeom>
              <a:avLst/>
              <a:gdLst>
                <a:gd name="T0" fmla="*/ 0 w 1956"/>
                <a:gd name="T1" fmla="*/ 0 h 1121"/>
                <a:gd name="T2" fmla="*/ 43 w 1956"/>
                <a:gd name="T3" fmla="*/ 0 h 1121"/>
                <a:gd name="T4" fmla="*/ 43 w 1956"/>
                <a:gd name="T5" fmla="*/ 163 h 1121"/>
                <a:gd name="T6" fmla="*/ 142 w 1956"/>
                <a:gd name="T7" fmla="*/ 163 h 1121"/>
                <a:gd name="T8" fmla="*/ 142 w 1956"/>
                <a:gd name="T9" fmla="*/ 319 h 1121"/>
                <a:gd name="T10" fmla="*/ 206 w 1956"/>
                <a:gd name="T11" fmla="*/ 319 h 1121"/>
                <a:gd name="T12" fmla="*/ 206 w 1956"/>
                <a:gd name="T13" fmla="*/ 482 h 1121"/>
                <a:gd name="T14" fmla="*/ 234 w 1956"/>
                <a:gd name="T15" fmla="*/ 482 h 1121"/>
                <a:gd name="T16" fmla="*/ 234 w 1956"/>
                <a:gd name="T17" fmla="*/ 638 h 1121"/>
                <a:gd name="T18" fmla="*/ 305 w 1956"/>
                <a:gd name="T19" fmla="*/ 638 h 1121"/>
                <a:gd name="T20" fmla="*/ 305 w 1956"/>
                <a:gd name="T21" fmla="*/ 801 h 1121"/>
                <a:gd name="T22" fmla="*/ 390 w 1956"/>
                <a:gd name="T23" fmla="*/ 801 h 1121"/>
                <a:gd name="T24" fmla="*/ 390 w 1956"/>
                <a:gd name="T25" fmla="*/ 958 h 1121"/>
                <a:gd name="T26" fmla="*/ 397 w 1956"/>
                <a:gd name="T27" fmla="*/ 958 h 1121"/>
                <a:gd name="T28" fmla="*/ 397 w 1956"/>
                <a:gd name="T29" fmla="*/ 1121 h 1121"/>
                <a:gd name="T30" fmla="*/ 1956 w 1956"/>
                <a:gd name="T31" fmla="*/ 1121 h 11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1956" h="1121">
                  <a:moveTo>
                    <a:pt x="0" y="0"/>
                  </a:moveTo>
                  <a:lnTo>
                    <a:pt x="43" y="0"/>
                  </a:lnTo>
                  <a:lnTo>
                    <a:pt x="43" y="163"/>
                  </a:lnTo>
                  <a:lnTo>
                    <a:pt x="142" y="163"/>
                  </a:lnTo>
                  <a:lnTo>
                    <a:pt x="142" y="319"/>
                  </a:lnTo>
                  <a:lnTo>
                    <a:pt x="206" y="319"/>
                  </a:lnTo>
                  <a:lnTo>
                    <a:pt x="206" y="482"/>
                  </a:lnTo>
                  <a:lnTo>
                    <a:pt x="234" y="482"/>
                  </a:lnTo>
                  <a:lnTo>
                    <a:pt x="234" y="638"/>
                  </a:lnTo>
                  <a:lnTo>
                    <a:pt x="305" y="638"/>
                  </a:lnTo>
                  <a:lnTo>
                    <a:pt x="305" y="801"/>
                  </a:lnTo>
                  <a:lnTo>
                    <a:pt x="390" y="801"/>
                  </a:lnTo>
                  <a:lnTo>
                    <a:pt x="390" y="958"/>
                  </a:lnTo>
                  <a:lnTo>
                    <a:pt x="397" y="958"/>
                  </a:lnTo>
                  <a:lnTo>
                    <a:pt x="397" y="1121"/>
                  </a:lnTo>
                  <a:lnTo>
                    <a:pt x="1956" y="1121"/>
                  </a:lnTo>
                </a:path>
              </a:pathLst>
            </a:custGeom>
            <a:noFill/>
            <a:ln w="190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2" name="Line 77">
              <a:extLst>
                <a:ext uri="{FF2B5EF4-FFF2-40B4-BE49-F238E27FC236}">
                  <a16:creationId xmlns:a16="http://schemas.microsoft.com/office/drawing/2014/main" id="{CF2A735F-5708-4DCF-B44F-48E079C4FCF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951538" y="955675"/>
              <a:ext cx="0" cy="2027238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3" name="Line 78">
              <a:extLst>
                <a:ext uri="{FF2B5EF4-FFF2-40B4-BE49-F238E27FC236}">
                  <a16:creationId xmlns:a16="http://schemas.microsoft.com/office/drawing/2014/main" id="{62997BD9-AA15-4BA9-80A5-9F6EA95801E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951538" y="2982913"/>
              <a:ext cx="3105150" cy="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4" name="Line 79">
              <a:extLst>
                <a:ext uri="{FF2B5EF4-FFF2-40B4-BE49-F238E27FC236}">
                  <a16:creationId xmlns:a16="http://schemas.microsoft.com/office/drawing/2014/main" id="{476D89EB-8253-4A29-8259-18EDD915202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951538" y="2982913"/>
              <a:ext cx="0" cy="66675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5" name="Rectangle 80">
              <a:extLst>
                <a:ext uri="{FF2B5EF4-FFF2-40B4-BE49-F238E27FC236}">
                  <a16:creationId xmlns:a16="http://schemas.microsoft.com/office/drawing/2014/main" id="{DCE9C56C-F9C0-4852-9568-0E64D7DF79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07088" y="3062288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6" name="Line 81">
              <a:extLst>
                <a:ext uri="{FF2B5EF4-FFF2-40B4-BE49-F238E27FC236}">
                  <a16:creationId xmlns:a16="http://schemas.microsoft.com/office/drawing/2014/main" id="{9297BBAB-D4FD-4273-867D-300EFC5ABA6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67451" y="2982913"/>
              <a:ext cx="0" cy="33338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7" name="Line 82">
              <a:extLst>
                <a:ext uri="{FF2B5EF4-FFF2-40B4-BE49-F238E27FC236}">
                  <a16:creationId xmlns:a16="http://schemas.microsoft.com/office/drawing/2014/main" id="{81758504-7623-4B7E-B36D-237630FF804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570663" y="2982913"/>
              <a:ext cx="0" cy="66675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8" name="Rectangle 83">
              <a:extLst>
                <a:ext uri="{FF2B5EF4-FFF2-40B4-BE49-F238E27FC236}">
                  <a16:creationId xmlns:a16="http://schemas.microsoft.com/office/drawing/2014/main" id="{8042393E-2523-416B-A8AE-ED72250FBE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26213" y="3062288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9" name="Line 84">
              <a:extLst>
                <a:ext uri="{FF2B5EF4-FFF2-40B4-BE49-F238E27FC236}">
                  <a16:creationId xmlns:a16="http://schemas.microsoft.com/office/drawing/2014/main" id="{45D8F8C9-6DE5-4099-A0B7-CBB04ECEA47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884988" y="2982913"/>
              <a:ext cx="0" cy="33338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0" name="Line 85">
              <a:extLst>
                <a:ext uri="{FF2B5EF4-FFF2-40B4-BE49-F238E27FC236}">
                  <a16:creationId xmlns:a16="http://schemas.microsoft.com/office/drawing/2014/main" id="{597BA813-A652-4483-989D-65BAC70B8B3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189788" y="2982913"/>
              <a:ext cx="0" cy="66675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1" name="Rectangle 86">
              <a:extLst>
                <a:ext uri="{FF2B5EF4-FFF2-40B4-BE49-F238E27FC236}">
                  <a16:creationId xmlns:a16="http://schemas.microsoft.com/office/drawing/2014/main" id="{6ED11E97-6DEC-4AB4-84C8-66D4EB2178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43751" y="3062288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2" name="Line 87">
              <a:extLst>
                <a:ext uri="{FF2B5EF4-FFF2-40B4-BE49-F238E27FC236}">
                  <a16:creationId xmlns:a16="http://schemas.microsoft.com/office/drawing/2014/main" id="{BA8F32FE-8AE2-4881-96D1-B23281FEB1E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504113" y="2982913"/>
              <a:ext cx="0" cy="33338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3" name="Line 88">
              <a:extLst>
                <a:ext uri="{FF2B5EF4-FFF2-40B4-BE49-F238E27FC236}">
                  <a16:creationId xmlns:a16="http://schemas.microsoft.com/office/drawing/2014/main" id="{363A6A11-B922-4DFD-879F-416537C4AE1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818438" y="2982913"/>
              <a:ext cx="0" cy="66675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4" name="Rectangle 89">
              <a:extLst>
                <a:ext uri="{FF2B5EF4-FFF2-40B4-BE49-F238E27FC236}">
                  <a16:creationId xmlns:a16="http://schemas.microsoft.com/office/drawing/2014/main" id="{3D611889-A547-4AFD-8EF4-93A92ADCA2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73988" y="3062288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3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5" name="Line 90">
              <a:extLst>
                <a:ext uri="{FF2B5EF4-FFF2-40B4-BE49-F238E27FC236}">
                  <a16:creationId xmlns:a16="http://schemas.microsoft.com/office/drawing/2014/main" id="{B70A6BFE-346F-4F86-A6B4-51D8A68CB57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123238" y="2982913"/>
              <a:ext cx="0" cy="33338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6" name="Line 91">
              <a:extLst>
                <a:ext uri="{FF2B5EF4-FFF2-40B4-BE49-F238E27FC236}">
                  <a16:creationId xmlns:a16="http://schemas.microsoft.com/office/drawing/2014/main" id="{97AA346C-D01E-4351-B238-A88B3483CA2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437563" y="2982913"/>
              <a:ext cx="0" cy="66675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7" name="Rectangle 92">
              <a:extLst>
                <a:ext uri="{FF2B5EF4-FFF2-40B4-BE49-F238E27FC236}">
                  <a16:creationId xmlns:a16="http://schemas.microsoft.com/office/drawing/2014/main" id="{B611D6CE-CF64-4C2C-A23A-374A2AACA1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93113" y="3062288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4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8" name="Line 93">
              <a:extLst>
                <a:ext uri="{FF2B5EF4-FFF2-40B4-BE49-F238E27FC236}">
                  <a16:creationId xmlns:a16="http://schemas.microsoft.com/office/drawing/2014/main" id="{5BE4A5DC-A121-4E83-B244-C0B2DAB5EF5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740776" y="2982913"/>
              <a:ext cx="0" cy="33338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9" name="Line 94">
              <a:extLst>
                <a:ext uri="{FF2B5EF4-FFF2-40B4-BE49-F238E27FC236}">
                  <a16:creationId xmlns:a16="http://schemas.microsoft.com/office/drawing/2014/main" id="{3FEC0BB5-9C6F-442F-BFCD-2C57717AB32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056688" y="2982913"/>
              <a:ext cx="0" cy="66675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0" name="Rectangle 95">
              <a:extLst>
                <a:ext uri="{FF2B5EF4-FFF2-40B4-BE49-F238E27FC236}">
                  <a16:creationId xmlns:a16="http://schemas.microsoft.com/office/drawing/2014/main" id="{7C85B12F-E624-405F-82F5-624D9C60DF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010651" y="3062288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5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97" name="グループ化 96">
            <a:extLst>
              <a:ext uri="{FF2B5EF4-FFF2-40B4-BE49-F238E27FC236}">
                <a16:creationId xmlns:a16="http://schemas.microsoft.com/office/drawing/2014/main" id="{12F2394B-D170-4FB8-8AE8-9B0E694B94A7}"/>
              </a:ext>
            </a:extLst>
          </p:cNvPr>
          <p:cNvGrpSpPr/>
          <p:nvPr/>
        </p:nvGrpSpPr>
        <p:grpSpPr>
          <a:xfrm>
            <a:off x="7162800" y="1606959"/>
            <a:ext cx="1431523" cy="461665"/>
            <a:chOff x="5346033" y="912919"/>
            <a:chExt cx="1429676" cy="461665"/>
          </a:xfrm>
        </p:grpSpPr>
        <p:cxnSp>
          <p:nvCxnSpPr>
            <p:cNvPr id="98" name="直線コネクタ 97">
              <a:extLst>
                <a:ext uri="{FF2B5EF4-FFF2-40B4-BE49-F238E27FC236}">
                  <a16:creationId xmlns:a16="http://schemas.microsoft.com/office/drawing/2014/main" id="{30DB176A-1373-43CC-9D09-7E68B42BB169}"/>
                </a:ext>
              </a:extLst>
            </p:cNvPr>
            <p:cNvCxnSpPr>
              <a:cxnSpLocks/>
            </p:cNvCxnSpPr>
            <p:nvPr/>
          </p:nvCxnSpPr>
          <p:spPr>
            <a:xfrm>
              <a:off x="5346033" y="1042011"/>
              <a:ext cx="211931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直線コネクタ 98">
              <a:extLst>
                <a:ext uri="{FF2B5EF4-FFF2-40B4-BE49-F238E27FC236}">
                  <a16:creationId xmlns:a16="http://schemas.microsoft.com/office/drawing/2014/main" id="{F44A34A2-72BA-40FE-9D40-46DB8E25FEEC}"/>
                </a:ext>
              </a:extLst>
            </p:cNvPr>
            <p:cNvCxnSpPr>
              <a:cxnSpLocks/>
            </p:cNvCxnSpPr>
            <p:nvPr/>
          </p:nvCxnSpPr>
          <p:spPr>
            <a:xfrm>
              <a:off x="5346033" y="1232511"/>
              <a:ext cx="211931" cy="0"/>
            </a:xfrm>
            <a:prstGeom prst="line">
              <a:avLst/>
            </a:prstGeom>
            <a:ln w="28575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0" name="テキスト ボックス 99">
              <a:extLst>
                <a:ext uri="{FF2B5EF4-FFF2-40B4-BE49-F238E27FC236}">
                  <a16:creationId xmlns:a16="http://schemas.microsoft.com/office/drawing/2014/main" id="{18B77906-6F8C-4957-BD03-8C02D0DE5F35}"/>
                </a:ext>
              </a:extLst>
            </p:cNvPr>
            <p:cNvSpPr txBox="1"/>
            <p:nvPr/>
          </p:nvSpPr>
          <p:spPr>
            <a:xfrm>
              <a:off x="5523621" y="912919"/>
              <a:ext cx="125208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. </a:t>
              </a:r>
              <a:r>
                <a:rPr kumimoji="1" lang="en-US" altLang="ja-JP" sz="12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ucleatum</a:t>
              </a:r>
              <a:r>
                <a:rPr kumimoji="1" lang="en-US" altLang="ja-JP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+)</a:t>
              </a:r>
            </a:p>
            <a:p>
              <a:r>
                <a:rPr kumimoji="1" lang="en-US" altLang="ja-JP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. </a:t>
              </a:r>
              <a:r>
                <a:rPr kumimoji="1" lang="en-US" altLang="ja-JP" sz="12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ucleatum</a:t>
              </a:r>
              <a:r>
                <a:rPr kumimoji="1" lang="en-US" altLang="ja-JP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-)</a:t>
              </a:r>
            </a:p>
          </p:txBody>
        </p:sp>
      </p:grpSp>
      <p:grpSp>
        <p:nvGrpSpPr>
          <p:cNvPr id="101" name="グループ化 100">
            <a:extLst>
              <a:ext uri="{FF2B5EF4-FFF2-40B4-BE49-F238E27FC236}">
                <a16:creationId xmlns:a16="http://schemas.microsoft.com/office/drawing/2014/main" id="{D2792EDC-5F1D-4669-A79B-12BF21564174}"/>
              </a:ext>
            </a:extLst>
          </p:cNvPr>
          <p:cNvGrpSpPr/>
          <p:nvPr/>
        </p:nvGrpSpPr>
        <p:grpSpPr>
          <a:xfrm>
            <a:off x="2895600" y="2140359"/>
            <a:ext cx="1431523" cy="461665"/>
            <a:chOff x="5346033" y="912919"/>
            <a:chExt cx="1429676" cy="461665"/>
          </a:xfrm>
        </p:grpSpPr>
        <p:cxnSp>
          <p:nvCxnSpPr>
            <p:cNvPr id="102" name="直線コネクタ 101">
              <a:extLst>
                <a:ext uri="{FF2B5EF4-FFF2-40B4-BE49-F238E27FC236}">
                  <a16:creationId xmlns:a16="http://schemas.microsoft.com/office/drawing/2014/main" id="{CFBFD050-034E-46E5-8163-3CF2A2BF8803}"/>
                </a:ext>
              </a:extLst>
            </p:cNvPr>
            <p:cNvCxnSpPr>
              <a:cxnSpLocks/>
            </p:cNvCxnSpPr>
            <p:nvPr/>
          </p:nvCxnSpPr>
          <p:spPr>
            <a:xfrm>
              <a:off x="5346033" y="1042011"/>
              <a:ext cx="211931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直線コネクタ 102">
              <a:extLst>
                <a:ext uri="{FF2B5EF4-FFF2-40B4-BE49-F238E27FC236}">
                  <a16:creationId xmlns:a16="http://schemas.microsoft.com/office/drawing/2014/main" id="{D37A4ADC-F153-4333-9A4B-B9D0D3B01A2D}"/>
                </a:ext>
              </a:extLst>
            </p:cNvPr>
            <p:cNvCxnSpPr>
              <a:cxnSpLocks/>
            </p:cNvCxnSpPr>
            <p:nvPr/>
          </p:nvCxnSpPr>
          <p:spPr>
            <a:xfrm>
              <a:off x="5346033" y="1232511"/>
              <a:ext cx="211931" cy="0"/>
            </a:xfrm>
            <a:prstGeom prst="line">
              <a:avLst/>
            </a:prstGeom>
            <a:ln w="28575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4" name="テキスト ボックス 103">
              <a:extLst>
                <a:ext uri="{FF2B5EF4-FFF2-40B4-BE49-F238E27FC236}">
                  <a16:creationId xmlns:a16="http://schemas.microsoft.com/office/drawing/2014/main" id="{2F1788CA-44CD-4171-AA42-7BB25E59E760}"/>
                </a:ext>
              </a:extLst>
            </p:cNvPr>
            <p:cNvSpPr txBox="1"/>
            <p:nvPr/>
          </p:nvSpPr>
          <p:spPr>
            <a:xfrm>
              <a:off x="5523621" y="912919"/>
              <a:ext cx="125208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. </a:t>
              </a:r>
              <a:r>
                <a:rPr kumimoji="1" lang="en-US" altLang="ja-JP" sz="12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ucleatum</a:t>
              </a:r>
              <a:r>
                <a:rPr kumimoji="1" lang="en-US" altLang="ja-JP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+)</a:t>
              </a:r>
            </a:p>
            <a:p>
              <a:r>
                <a:rPr kumimoji="1" lang="en-US" altLang="ja-JP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. </a:t>
              </a:r>
              <a:r>
                <a:rPr kumimoji="1" lang="en-US" altLang="ja-JP" sz="12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ucleatum</a:t>
              </a:r>
              <a:r>
                <a:rPr kumimoji="1" lang="en-US" altLang="ja-JP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-)</a:t>
              </a:r>
            </a:p>
          </p:txBody>
        </p:sp>
      </p:grp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520C3E0-BF5C-4323-9AC7-2F9A730FFF49}"/>
              </a:ext>
            </a:extLst>
          </p:cNvPr>
          <p:cNvSpPr txBox="1"/>
          <p:nvPr/>
        </p:nvSpPr>
        <p:spPr>
          <a:xfrm>
            <a:off x="277702" y="5247382"/>
            <a:ext cx="8028097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GB" altLang="ja-JP" sz="16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. 1. </a:t>
            </a:r>
            <a:r>
              <a:rPr lang="en-GB" altLang="ja-JP" sz="1600" b="1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. </a:t>
            </a:r>
            <a:r>
              <a:rPr lang="en-GB" altLang="ja-JP" sz="1600" b="1" i="1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ucleatum</a:t>
            </a:r>
            <a:r>
              <a:rPr lang="en-GB" altLang="ja-JP" sz="16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status and patients’ prognosis.</a:t>
            </a:r>
            <a:endParaRPr lang="ja-JP" altLang="ja-JP" sz="160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GB" altLang="ja-JP" sz="16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A) Overall survival after curative resection of colorectal cancer liver metastases, according to </a:t>
            </a:r>
            <a:r>
              <a:rPr lang="en-GB" altLang="ja-JP" sz="1600" i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. </a:t>
            </a:r>
            <a:r>
              <a:rPr lang="en-GB" altLang="ja-JP" sz="1600" i="1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ucleatum</a:t>
            </a:r>
            <a:r>
              <a:rPr lang="en-GB" altLang="ja-JP" sz="16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DNA status. (B) Relapse-free survival after curative resection of colorectal cancer liver metastases, according to </a:t>
            </a:r>
            <a:r>
              <a:rPr lang="en-GB" altLang="ja-JP" sz="1600" i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. </a:t>
            </a:r>
            <a:r>
              <a:rPr lang="en-GB" altLang="ja-JP" sz="1600" i="1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ucleatum</a:t>
            </a:r>
            <a:r>
              <a:rPr lang="en-GB" altLang="ja-JP" sz="160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DNA status</a:t>
            </a:r>
            <a:r>
              <a:rPr lang="en-GB" altLang="ja-JP" sz="16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.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52469681"/>
      </p:ext>
    </p:extLst>
  </p:cSld>
  <p:clrMapOvr>
    <a:masterClrMapping/>
  </p:clrMapOvr>
  <p:transition/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356</TotalTime>
  <Words>188</Words>
  <Application>Microsoft Office PowerPoint</Application>
  <PresentationFormat>画面に合わせる (4:3)</PresentationFormat>
  <Paragraphs>86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Times New Roman</vt:lpstr>
      <vt:lpstr>Office Theme</vt:lpstr>
      <vt:lpstr>PowerPoint プレゼンテーション</vt:lpstr>
    </vt:vector>
  </TitlesOfParts>
  <Company>Partners HealthCare System, Inc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artners Information Systems</dc:creator>
  <cp:lastModifiedBy>坂本 悠樹</cp:lastModifiedBy>
  <cp:revision>1065</cp:revision>
  <cp:lastPrinted>2019-01-07T05:05:10Z</cp:lastPrinted>
  <dcterms:created xsi:type="dcterms:W3CDTF">2015-04-16T18:54:03Z</dcterms:created>
  <dcterms:modified xsi:type="dcterms:W3CDTF">2021-08-17T12:03:55Z</dcterms:modified>
</cp:coreProperties>
</file>